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62" r:id="rId4"/>
    <p:sldId id="257" r:id="rId5"/>
    <p:sldId id="258" r:id="rId6"/>
    <p:sldId id="259" r:id="rId7"/>
    <p:sldId id="260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574" y="1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B0C3A3-3775-0A8C-9588-9EEEC8B1B7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EC5EB3D-561B-9DFF-D6D1-A47DDD0CD2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6B11E2-0FC9-0D64-B69A-DCC825485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BC2A17-AD46-09B2-2759-3340B1AA5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85D203-67B8-D1C1-082D-3B29573F5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8041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E1DC02-8A4B-0E36-9F35-24D4A14EEE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6F7D77-FED3-8A27-A5C9-1A5048A2E6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39BD8E-51F6-F8F0-3476-3104302B00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A22D91-C593-269D-267C-924C705D98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41F1B4-CBE3-3DE4-4AD4-F5DAE7817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36213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5F0A04-2C73-596D-7C1E-91375E5570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C7DE7F-3918-E48D-7C34-8553D3C032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638743-C2AC-BAFC-AA02-02C06D969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419EEA-1234-9189-3609-1444B9A86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8A84D7-9096-A110-C2B4-2350373DE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8449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731CBF-6684-0D03-DB6B-BA92E7FFFC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0A7972-EDBB-573A-89BB-8F1307B9C2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4F8344-DBC4-E6D9-FBF1-8983ECF1B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5C21F3-CA62-DF0C-117C-F21E94612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4FBD3E-9AA9-6E09-C85B-FECCA57B1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45710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F71F24-946B-5B60-0545-B8CD600260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3E0A42-26DC-0E22-5DC0-F0D886C354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151727-EBF1-C417-0475-5432B8525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EDD694-B6BD-0410-7C44-10BDD2377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3BA8FE-755E-AE9A-12C2-97C62601C6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5163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34A5CD-334D-9EB0-B345-79F24F1361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2BBD94-3AE6-0E04-F836-6E7678C80F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E2EF99-7E6F-A760-0365-0C86D26D68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CED9F6-ADC6-104B-2A61-A8ABFE6E4F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945D4C-5583-69E3-A1D7-56981DBF1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5DE1A2-4D7D-5F31-50D1-63323A0A7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7242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A4FC5-E857-D943-CFAB-AEF3A3931D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62BB9B-A9FF-B585-2D9B-3020DCDF7D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DE5A9B-C1CB-D86D-9825-AA2637E6CA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D7BD83-6788-3335-E9B9-D77E7C9BC8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5B9E1D-85FF-4BE3-7024-FFFE451E97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419EE0-9C6C-8DF1-867D-A481BDB75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73E33F-E346-FD4C-2409-0257CB1E7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F0215B-1E34-A6FB-4278-C812BCED5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3908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5F14E8-3F46-2251-0BED-A1094F848F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2AB46B-5034-8B1F-6EB7-186C4F7B57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0A76D5F-D023-C33A-FF7F-B1C0FB433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324B624-6E68-AA66-58C1-F547692DAF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2930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1781933-7098-26FF-C3ED-0FA6A8B442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67258BE-A2CE-A7D7-225F-A362FF67F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6B453F5-695B-6DC8-5EDE-A0110ADB19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9021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FCDD89-BA0D-78D2-3732-5C5CED92A2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6E51A3-2A21-2154-F6C2-F6561AB38B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24C9DD-B008-471C-863B-AB07CCA8B0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E9F2D8-7F76-FD3B-DF46-C185F2F2E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D4196E-95A1-15FD-15D6-3157DE1341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485016-77F4-2333-3D15-A0B6EFE08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0815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C5BC12-6E44-8F83-BADD-F9F4E54839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1819C43-B0A5-0E74-D0E9-524710EB63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CC8222-9DAE-9068-BB16-6837CD4CBE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230330-1093-7EF4-2CD4-621D6BB55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44B1F2-869B-59A2-F874-535F4B8C1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256704-BE22-8DB3-1864-CADC6B704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2680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52D120D-25B4-5993-DC9D-CCD9D2F07F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6C7195-8C2C-8641-42DB-7E8BE24DB0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A101CB-3E8F-1391-A034-B2A58EF3C8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E1065E-0F1E-4D57-8C96-53B576953B5C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B847EA-4E07-8489-6747-2BC52DA0BB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491F89-8753-0502-DAEF-B511F51A2F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E301E-13FB-4F60-9673-14D8FDF7D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0471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g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jpg"/><Relationship Id="rId5" Type="http://schemas.openxmlformats.org/officeDocument/2006/relationships/image" Target="../media/image21.jpg"/><Relationship Id="rId4" Type="http://schemas.openxmlformats.org/officeDocument/2006/relationships/image" Target="../media/image20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>
            <a:extLst>
              <a:ext uri="{FF2B5EF4-FFF2-40B4-BE49-F238E27FC236}">
                <a16:creationId xmlns:a16="http://schemas.microsoft.com/office/drawing/2014/main" id="{7E5EAE3C-DB1C-DAE3-F6EE-6FDF7ACC72E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315" t="15620" r="39505" b="78480"/>
          <a:stretch/>
        </p:blipFill>
        <p:spPr>
          <a:xfrm rot="16200000">
            <a:off x="806952" y="1411147"/>
            <a:ext cx="432000" cy="5400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39D0E28A-B3B3-7761-AF80-A198DAA5F02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921" t="33445" r="26783" b="59666"/>
          <a:stretch/>
        </p:blipFill>
        <p:spPr>
          <a:xfrm rot="16200000">
            <a:off x="638141" y="758472"/>
            <a:ext cx="76962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7074703C-07FB-BCE2-D72B-CC14B8780436}"/>
              </a:ext>
            </a:extLst>
          </p:cNvPr>
          <p:cNvSpPr txBox="1"/>
          <p:nvPr/>
        </p:nvSpPr>
        <p:spPr>
          <a:xfrm>
            <a:off x="1266317" y="420667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λ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P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AEBE44E-DE67-DB2D-C922-3B2466850340}"/>
              </a:ext>
            </a:extLst>
          </p:cNvPr>
          <p:cNvSpPr txBox="1"/>
          <p:nvPr/>
        </p:nvSpPr>
        <p:spPr>
          <a:xfrm>
            <a:off x="1261740" y="937531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F72C62B-AFA0-16B0-9603-8FE7BEC82781}"/>
              </a:ext>
            </a:extLst>
          </p:cNvPr>
          <p:cNvSpPr txBox="1"/>
          <p:nvPr/>
        </p:nvSpPr>
        <p:spPr>
          <a:xfrm>
            <a:off x="1261740" y="1521301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E1197DD-AAD7-14B1-9C5A-794473661774}"/>
              </a:ext>
            </a:extLst>
          </p:cNvPr>
          <p:cNvSpPr txBox="1"/>
          <p:nvPr/>
        </p:nvSpPr>
        <p:spPr>
          <a:xfrm>
            <a:off x="752950" y="419158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CB3433D-68C0-6980-11F2-08A4704F22D5}"/>
              </a:ext>
            </a:extLst>
          </p:cNvPr>
          <p:cNvSpPr txBox="1"/>
          <p:nvPr/>
        </p:nvSpPr>
        <p:spPr>
          <a:xfrm>
            <a:off x="1003714" y="419158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8B8518C-3F5F-5C1F-2478-B18DF8C735D0}"/>
              </a:ext>
            </a:extLst>
          </p:cNvPr>
          <p:cNvSpPr txBox="1"/>
          <p:nvPr/>
        </p:nvSpPr>
        <p:spPr>
          <a:xfrm>
            <a:off x="328809" y="92465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7F1B7FE-CC81-B2AF-B426-1036DE2AE867}"/>
              </a:ext>
            </a:extLst>
          </p:cNvPr>
          <p:cNvSpPr txBox="1"/>
          <p:nvPr/>
        </p:nvSpPr>
        <p:spPr>
          <a:xfrm>
            <a:off x="376984" y="153142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0161BA2-C6E0-373E-0BA4-88F964B1F85A}"/>
              </a:ext>
            </a:extLst>
          </p:cNvPr>
          <p:cNvCxnSpPr/>
          <p:nvPr/>
        </p:nvCxnSpPr>
        <p:spPr>
          <a:xfrm>
            <a:off x="630264" y="1042287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9F542845-C197-3098-94BA-3FF64952E50B}"/>
              </a:ext>
            </a:extLst>
          </p:cNvPr>
          <p:cNvCxnSpPr/>
          <p:nvPr/>
        </p:nvCxnSpPr>
        <p:spPr>
          <a:xfrm>
            <a:off x="630264" y="1649362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B02F1BDB-845E-B47D-4B0D-5AFC4B3370AC}"/>
              </a:ext>
            </a:extLst>
          </p:cNvPr>
          <p:cNvSpPr txBox="1"/>
          <p:nvPr/>
        </p:nvSpPr>
        <p:spPr>
          <a:xfrm>
            <a:off x="333459" y="374472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210A6DD-7DD3-8CA4-EAA5-BBE86A14139E}"/>
              </a:ext>
            </a:extLst>
          </p:cNvPr>
          <p:cNvSpPr txBox="1"/>
          <p:nvPr/>
        </p:nvSpPr>
        <p:spPr>
          <a:xfrm>
            <a:off x="666223" y="1876677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949DE06-230D-A48A-56AE-B8E51EB3AC29}"/>
              </a:ext>
            </a:extLst>
          </p:cNvPr>
          <p:cNvSpPr txBox="1"/>
          <p:nvPr/>
        </p:nvSpPr>
        <p:spPr>
          <a:xfrm>
            <a:off x="23357" y="35536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72" name="Picture 71">
            <a:extLst>
              <a:ext uri="{FF2B5EF4-FFF2-40B4-BE49-F238E27FC236}">
                <a16:creationId xmlns:a16="http://schemas.microsoft.com/office/drawing/2014/main" id="{D89A7355-9C4E-DFF5-FCAA-60C4237A716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" t="-324" r="307" b="364"/>
          <a:stretch/>
        </p:blipFill>
        <p:spPr>
          <a:xfrm rot="16200000">
            <a:off x="-514110" y="2993783"/>
            <a:ext cx="3866823" cy="24966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C0825548-F6B4-D715-8BC8-58D205842E0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5" t="-452" r="586" b="705"/>
          <a:stretch/>
        </p:blipFill>
        <p:spPr>
          <a:xfrm rot="16200000">
            <a:off x="3306446" y="1764881"/>
            <a:ext cx="3212415" cy="42589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4" name="Rectangle 73">
            <a:extLst>
              <a:ext uri="{FF2B5EF4-FFF2-40B4-BE49-F238E27FC236}">
                <a16:creationId xmlns:a16="http://schemas.microsoft.com/office/drawing/2014/main" id="{1FA104C9-0E9E-16A4-7A58-7B77572513E4}"/>
              </a:ext>
            </a:extLst>
          </p:cNvPr>
          <p:cNvSpPr/>
          <p:nvPr/>
        </p:nvSpPr>
        <p:spPr>
          <a:xfrm>
            <a:off x="976088" y="3333750"/>
            <a:ext cx="211362" cy="2397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846CBC19-BDC1-B1D1-3CB1-389DC889707B}"/>
              </a:ext>
            </a:extLst>
          </p:cNvPr>
          <p:cNvSpPr/>
          <p:nvPr/>
        </p:nvSpPr>
        <p:spPr>
          <a:xfrm>
            <a:off x="3465010" y="3577176"/>
            <a:ext cx="268789" cy="2397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4AA4A9D5-8F07-B072-D937-89EEA73A5692}"/>
              </a:ext>
            </a:extLst>
          </p:cNvPr>
          <p:cNvSpPr txBox="1"/>
          <p:nvPr/>
        </p:nvSpPr>
        <p:spPr>
          <a:xfrm>
            <a:off x="328809" y="3366538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7F1544B-BE8C-A24E-5BF2-390F20FC3D89}"/>
              </a:ext>
            </a:extLst>
          </p:cNvPr>
          <p:cNvSpPr txBox="1"/>
          <p:nvPr/>
        </p:nvSpPr>
        <p:spPr>
          <a:xfrm>
            <a:off x="3369264" y="3325655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6396717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B76021E-B433-6217-CEA4-2F6097B11A62}"/>
              </a:ext>
            </a:extLst>
          </p:cNvPr>
          <p:cNvSpPr txBox="1"/>
          <p:nvPr/>
        </p:nvSpPr>
        <p:spPr>
          <a:xfrm>
            <a:off x="149066" y="23471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A5F6F2F-B4DB-BF02-10B0-5C330998A6E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79" t="33188" r="36775" b="57136"/>
          <a:stretch/>
        </p:blipFill>
        <p:spPr>
          <a:xfrm rot="5400000">
            <a:off x="1185058" y="840351"/>
            <a:ext cx="391180" cy="5029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D192FB1-2582-FBF9-74E3-78FB7F73520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52" t="73640" r="75202" b="16684"/>
          <a:stretch/>
        </p:blipFill>
        <p:spPr>
          <a:xfrm rot="5400000">
            <a:off x="643470" y="839622"/>
            <a:ext cx="391180" cy="5029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D8E482A-155D-5DFB-3B25-014153E5004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57" t="33022" r="78728" b="57165"/>
          <a:stretch/>
        </p:blipFill>
        <p:spPr>
          <a:xfrm rot="5400000">
            <a:off x="643611" y="1254548"/>
            <a:ext cx="391180" cy="5027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A307798-6F12-F2B1-4ABA-46756ABC095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620" t="29758" r="35019" b="52083"/>
          <a:stretch/>
        </p:blipFill>
        <p:spPr>
          <a:xfrm rot="5400000">
            <a:off x="1182798" y="1254446"/>
            <a:ext cx="391180" cy="5029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6806E65-2D3A-8F89-6EE6-9852B664CDD5}"/>
              </a:ext>
            </a:extLst>
          </p:cNvPr>
          <p:cNvSpPr txBox="1"/>
          <p:nvPr/>
        </p:nvSpPr>
        <p:spPr>
          <a:xfrm>
            <a:off x="1629861" y="954339"/>
            <a:ext cx="341600" cy="229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B: H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BA297EB-8B71-5332-E6F3-433643F0B51D}"/>
              </a:ext>
            </a:extLst>
          </p:cNvPr>
          <p:cNvSpPr txBox="1"/>
          <p:nvPr/>
        </p:nvSpPr>
        <p:spPr>
          <a:xfrm>
            <a:off x="1629861" y="1322850"/>
            <a:ext cx="520761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Ser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14-3-3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6DE79B7-EDF1-EE0A-F663-8D0CAF9EAC4C}"/>
              </a:ext>
            </a:extLst>
          </p:cNvPr>
          <p:cNvSpPr txBox="1"/>
          <p:nvPr/>
        </p:nvSpPr>
        <p:spPr>
          <a:xfrm>
            <a:off x="751797" y="670875"/>
            <a:ext cx="138551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516A2E1-95CC-E52C-288F-B11B9F5E2645}"/>
              </a:ext>
            </a:extLst>
          </p:cNvPr>
          <p:cNvSpPr txBox="1"/>
          <p:nvPr/>
        </p:nvSpPr>
        <p:spPr>
          <a:xfrm>
            <a:off x="592934" y="670875"/>
            <a:ext cx="138551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ACED603-901A-D623-8727-DB330322800C}"/>
              </a:ext>
            </a:extLst>
          </p:cNvPr>
          <p:cNvSpPr txBox="1"/>
          <p:nvPr/>
        </p:nvSpPr>
        <p:spPr>
          <a:xfrm>
            <a:off x="910660" y="675652"/>
            <a:ext cx="156467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47C3F5F-7825-76A0-BC8E-71A4073AA9D0}"/>
              </a:ext>
            </a:extLst>
          </p:cNvPr>
          <p:cNvSpPr txBox="1"/>
          <p:nvPr/>
        </p:nvSpPr>
        <p:spPr>
          <a:xfrm>
            <a:off x="1293384" y="667233"/>
            <a:ext cx="138551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AD382AA-B07D-F28A-E994-44D1092AE8D6}"/>
              </a:ext>
            </a:extLst>
          </p:cNvPr>
          <p:cNvSpPr txBox="1"/>
          <p:nvPr/>
        </p:nvSpPr>
        <p:spPr>
          <a:xfrm>
            <a:off x="1452248" y="672010"/>
            <a:ext cx="156467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EC958A3-B1F0-9147-4704-B21FAE1EE434}"/>
              </a:ext>
            </a:extLst>
          </p:cNvPr>
          <p:cNvSpPr txBox="1"/>
          <p:nvPr/>
        </p:nvSpPr>
        <p:spPr>
          <a:xfrm>
            <a:off x="587283" y="495815"/>
            <a:ext cx="309750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9C68DDA-A771-ED9B-E836-B4763972194D}"/>
              </a:ext>
            </a:extLst>
          </p:cNvPr>
          <p:cNvSpPr txBox="1"/>
          <p:nvPr/>
        </p:nvSpPr>
        <p:spPr>
          <a:xfrm>
            <a:off x="1093695" y="494800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Ser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IP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CC8D1F2-7023-C43C-F4F1-01203F94BEB0}"/>
              </a:ext>
            </a:extLst>
          </p:cNvPr>
          <p:cNvSpPr txBox="1"/>
          <p:nvPr/>
        </p:nvSpPr>
        <p:spPr>
          <a:xfrm>
            <a:off x="1615683" y="677282"/>
            <a:ext cx="7409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 h 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80142AF-FD4B-CDA6-B03A-93E14E90297B}"/>
              </a:ext>
            </a:extLst>
          </p:cNvPr>
          <p:cNvCxnSpPr>
            <a:cxnSpLocks/>
          </p:cNvCxnSpPr>
          <p:nvPr/>
        </p:nvCxnSpPr>
        <p:spPr>
          <a:xfrm>
            <a:off x="636605" y="703788"/>
            <a:ext cx="400227" cy="113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FF9E2DE-43A2-D4EC-4B86-9DA235799242}"/>
              </a:ext>
            </a:extLst>
          </p:cNvPr>
          <p:cNvCxnSpPr>
            <a:cxnSpLocks/>
          </p:cNvCxnSpPr>
          <p:nvPr/>
        </p:nvCxnSpPr>
        <p:spPr>
          <a:xfrm>
            <a:off x="1171785" y="703788"/>
            <a:ext cx="400227" cy="113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DEB99349-B0F5-BC2C-1D19-70F1C2F7B9E3}"/>
              </a:ext>
            </a:extLst>
          </p:cNvPr>
          <p:cNvSpPr txBox="1"/>
          <p:nvPr/>
        </p:nvSpPr>
        <p:spPr>
          <a:xfrm>
            <a:off x="265774" y="697386"/>
            <a:ext cx="242066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8F3EFD3-21BC-21F0-1C7A-0940397FCEB6}"/>
              </a:ext>
            </a:extLst>
          </p:cNvPr>
          <p:cNvSpPr txBox="1"/>
          <p:nvPr/>
        </p:nvSpPr>
        <p:spPr>
          <a:xfrm>
            <a:off x="1049919" y="690148"/>
            <a:ext cx="230122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7CCF9DF-4A28-BC88-DBC8-8EE8B2166B8F}"/>
              </a:ext>
            </a:extLst>
          </p:cNvPr>
          <p:cNvSpPr txBox="1"/>
          <p:nvPr/>
        </p:nvSpPr>
        <p:spPr>
          <a:xfrm>
            <a:off x="671324" y="305778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 O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2343669-8529-9D39-4AB2-28447ED279B3}"/>
              </a:ext>
            </a:extLst>
          </p:cNvPr>
          <p:cNvSpPr txBox="1"/>
          <p:nvPr/>
        </p:nvSpPr>
        <p:spPr>
          <a:xfrm>
            <a:off x="186673" y="98201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0009B9F-83E6-E65D-A3E0-E82C19935862}"/>
              </a:ext>
            </a:extLst>
          </p:cNvPr>
          <p:cNvCxnSpPr/>
          <p:nvPr/>
        </p:nvCxnSpPr>
        <p:spPr>
          <a:xfrm>
            <a:off x="488128" y="1099639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44AB381-3641-9820-9184-DFA5957F99F2}"/>
              </a:ext>
            </a:extLst>
          </p:cNvPr>
          <p:cNvSpPr txBox="1"/>
          <p:nvPr/>
        </p:nvSpPr>
        <p:spPr>
          <a:xfrm>
            <a:off x="186673" y="127396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54B8F737-484E-3390-8A9D-FCD964BBA8CC}"/>
              </a:ext>
            </a:extLst>
          </p:cNvPr>
          <p:cNvCxnSpPr/>
          <p:nvPr/>
        </p:nvCxnSpPr>
        <p:spPr>
          <a:xfrm>
            <a:off x="488128" y="139159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A6E89060-2079-CB41-52AD-7B6B14D236AB}"/>
              </a:ext>
            </a:extLst>
          </p:cNvPr>
          <p:cNvSpPr txBox="1"/>
          <p:nvPr/>
        </p:nvSpPr>
        <p:spPr>
          <a:xfrm>
            <a:off x="523645" y="1678844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2F2E7E21-18A8-8045-3BD4-272C148E88D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0" t="207" r="-363" b="515"/>
          <a:stretch/>
        </p:blipFill>
        <p:spPr>
          <a:xfrm rot="5400000">
            <a:off x="2828205" y="123068"/>
            <a:ext cx="2689605" cy="2912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FF39D600-D427-D5AB-2332-872029BC1F2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1" t="1207" r="2061" b="698"/>
          <a:stretch/>
        </p:blipFill>
        <p:spPr>
          <a:xfrm rot="5400000">
            <a:off x="5964589" y="107171"/>
            <a:ext cx="2581707" cy="28367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5D182474-C633-1B1C-51C8-13A7276B0D2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30" t="-687" r="-359" b="-1734"/>
          <a:stretch/>
        </p:blipFill>
        <p:spPr>
          <a:xfrm rot="5400000">
            <a:off x="8417358" y="571202"/>
            <a:ext cx="3017434" cy="23444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9" name="Rectangle 58">
            <a:extLst>
              <a:ext uri="{FF2B5EF4-FFF2-40B4-BE49-F238E27FC236}">
                <a16:creationId xmlns:a16="http://schemas.microsoft.com/office/drawing/2014/main" id="{82E17863-6A54-ACCC-97EF-8291396E32A9}"/>
              </a:ext>
            </a:extLst>
          </p:cNvPr>
          <p:cNvSpPr/>
          <p:nvPr/>
        </p:nvSpPr>
        <p:spPr>
          <a:xfrm>
            <a:off x="3181615" y="639143"/>
            <a:ext cx="301869" cy="2689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093816F2-0BFE-5DF0-530D-E91C11631281}"/>
              </a:ext>
            </a:extLst>
          </p:cNvPr>
          <p:cNvSpPr/>
          <p:nvPr/>
        </p:nvSpPr>
        <p:spPr>
          <a:xfrm>
            <a:off x="4376935" y="1678844"/>
            <a:ext cx="301869" cy="2689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4E2D63FC-1F78-718B-2093-924E964D490F}"/>
              </a:ext>
            </a:extLst>
          </p:cNvPr>
          <p:cNvSpPr/>
          <p:nvPr/>
        </p:nvSpPr>
        <p:spPr>
          <a:xfrm>
            <a:off x="7461397" y="555662"/>
            <a:ext cx="301869" cy="2689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5AA14DF8-E5DB-D326-FD79-9DDFAF08291C}"/>
              </a:ext>
            </a:extLst>
          </p:cNvPr>
          <p:cNvSpPr/>
          <p:nvPr/>
        </p:nvSpPr>
        <p:spPr>
          <a:xfrm>
            <a:off x="10001251" y="1897909"/>
            <a:ext cx="416316" cy="3118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BBF3AD2-8EBE-99AD-12BB-81554FA55241}"/>
              </a:ext>
            </a:extLst>
          </p:cNvPr>
          <p:cNvSpPr txBox="1"/>
          <p:nvPr/>
        </p:nvSpPr>
        <p:spPr>
          <a:xfrm>
            <a:off x="3068999" y="954339"/>
            <a:ext cx="341600" cy="229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B: H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ECEFC52-9B61-79EA-DC7E-B0F496352CE9}"/>
              </a:ext>
            </a:extLst>
          </p:cNvPr>
          <p:cNvSpPr txBox="1"/>
          <p:nvPr/>
        </p:nvSpPr>
        <p:spPr>
          <a:xfrm>
            <a:off x="3900726" y="1628769"/>
            <a:ext cx="341600" cy="229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B: HA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6807CCD-97B0-082C-EE83-D93D090802B5}"/>
              </a:ext>
            </a:extLst>
          </p:cNvPr>
          <p:cNvSpPr txBox="1"/>
          <p:nvPr/>
        </p:nvSpPr>
        <p:spPr>
          <a:xfrm>
            <a:off x="7385851" y="351472"/>
            <a:ext cx="520761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Ser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14-3-3)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B190C56-2DCA-A94C-E7D8-3A4E9C159206}"/>
              </a:ext>
            </a:extLst>
          </p:cNvPr>
          <p:cNvSpPr txBox="1"/>
          <p:nvPr/>
        </p:nvSpPr>
        <p:spPr>
          <a:xfrm>
            <a:off x="9830601" y="2256472"/>
            <a:ext cx="520761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Ser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14-3-3)</a:t>
            </a:r>
          </a:p>
        </p:txBody>
      </p:sp>
    </p:spTree>
    <p:extLst>
      <p:ext uri="{BB962C8B-B14F-4D97-AF65-F5344CB8AC3E}">
        <p14:creationId xmlns:p14="http://schemas.microsoft.com/office/powerpoint/2010/main" val="23718808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0C91C31-D9F5-A63E-0620-94CAC9D05B75}"/>
              </a:ext>
            </a:extLst>
          </p:cNvPr>
          <p:cNvSpPr txBox="1"/>
          <p:nvPr/>
        </p:nvSpPr>
        <p:spPr>
          <a:xfrm>
            <a:off x="197051" y="19661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4D4C91A-7F3E-7A1E-DDB5-B840B9DD801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933" t="24848" r="19016" b="64485"/>
          <a:stretch/>
        </p:blipFill>
        <p:spPr>
          <a:xfrm rot="16200000">
            <a:off x="834032" y="559159"/>
            <a:ext cx="297521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1E6D0A8-F089-8292-4228-0A27E7C01A9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741" t="65232" r="18208" b="25212"/>
          <a:stretch/>
        </p:blipFill>
        <p:spPr>
          <a:xfrm rot="16200000">
            <a:off x="1460511" y="559159"/>
            <a:ext cx="297521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2B041AE-86C3-80EB-AB38-94450394E55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680" t="16106" r="18161" b="74459"/>
          <a:stretch/>
        </p:blipFill>
        <p:spPr>
          <a:xfrm rot="16200000">
            <a:off x="834055" y="882982"/>
            <a:ext cx="297521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CF47E5C-0831-EA78-18FE-396D372650D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573" t="24874" r="51268" b="65623"/>
          <a:stretch/>
        </p:blipFill>
        <p:spPr>
          <a:xfrm rot="16200000">
            <a:off x="1460511" y="882982"/>
            <a:ext cx="297521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69EBEF5-F0DC-8B2D-40EF-F7ACCEC22F6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494" t="15962" r="29318" b="74602"/>
          <a:stretch/>
        </p:blipFill>
        <p:spPr>
          <a:xfrm rot="16200000">
            <a:off x="834054" y="1206748"/>
            <a:ext cx="297521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5D98001-5D57-2EC1-9CB2-F74B3F05CD7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16" t="24677" r="64096" b="65820"/>
          <a:stretch/>
        </p:blipFill>
        <p:spPr>
          <a:xfrm rot="16200000">
            <a:off x="1460510" y="1206748"/>
            <a:ext cx="297521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91AC71E-396B-C49E-BDF0-9E173EC01AB0}"/>
              </a:ext>
            </a:extLst>
          </p:cNvPr>
          <p:cNvSpPr txBox="1"/>
          <p:nvPr/>
        </p:nvSpPr>
        <p:spPr>
          <a:xfrm>
            <a:off x="1905318" y="665245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Ser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8D3C85D-8DC1-2863-1592-EAB4A2A6EE42}"/>
              </a:ext>
            </a:extLst>
          </p:cNvPr>
          <p:cNvSpPr txBox="1"/>
          <p:nvPr/>
        </p:nvSpPr>
        <p:spPr>
          <a:xfrm rot="18900000">
            <a:off x="592393" y="480342"/>
            <a:ext cx="306293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2868C2F-0CE1-280F-EC85-A7F93652FD63}"/>
              </a:ext>
            </a:extLst>
          </p:cNvPr>
          <p:cNvSpPr txBox="1"/>
          <p:nvPr/>
        </p:nvSpPr>
        <p:spPr>
          <a:xfrm>
            <a:off x="1281776" y="272311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I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7EDEFA1-F5DC-5710-3242-299A93939934}"/>
              </a:ext>
            </a:extLst>
          </p:cNvPr>
          <p:cNvSpPr txBox="1"/>
          <p:nvPr/>
        </p:nvSpPr>
        <p:spPr>
          <a:xfrm rot="18900000">
            <a:off x="797840" y="487836"/>
            <a:ext cx="2850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5E89FB8-5784-3BE3-5DB4-77C9E67AEF43}"/>
              </a:ext>
            </a:extLst>
          </p:cNvPr>
          <p:cNvSpPr txBox="1"/>
          <p:nvPr/>
        </p:nvSpPr>
        <p:spPr>
          <a:xfrm rot="18900000">
            <a:off x="986854" y="472848"/>
            <a:ext cx="327489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λ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6D65E6A-A8A4-0A6F-04FA-DCE21E070AD3}"/>
              </a:ext>
            </a:extLst>
          </p:cNvPr>
          <p:cNvSpPr txBox="1"/>
          <p:nvPr/>
        </p:nvSpPr>
        <p:spPr>
          <a:xfrm>
            <a:off x="1905318" y="1102848"/>
            <a:ext cx="45467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7BEB248-AB67-8100-3950-C149C9CE6D02}"/>
              </a:ext>
            </a:extLst>
          </p:cNvPr>
          <p:cNvSpPr txBox="1"/>
          <p:nvPr/>
        </p:nvSpPr>
        <p:spPr>
          <a:xfrm>
            <a:off x="1905318" y="1439551"/>
            <a:ext cx="428174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371F227-0CEE-8484-8E2E-35DE3E3C9B24}"/>
              </a:ext>
            </a:extLst>
          </p:cNvPr>
          <p:cNvSpPr txBox="1"/>
          <p:nvPr/>
        </p:nvSpPr>
        <p:spPr>
          <a:xfrm rot="18900000">
            <a:off x="1232585" y="480342"/>
            <a:ext cx="306293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34C1587-7FA5-4B4A-B472-57CEA0E52A88}"/>
              </a:ext>
            </a:extLst>
          </p:cNvPr>
          <p:cNvSpPr txBox="1"/>
          <p:nvPr/>
        </p:nvSpPr>
        <p:spPr>
          <a:xfrm rot="18900000">
            <a:off x="1438033" y="487836"/>
            <a:ext cx="2850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9E17BBD-1C1A-29D7-83C3-C4F444DB3CF7}"/>
              </a:ext>
            </a:extLst>
          </p:cNvPr>
          <p:cNvSpPr txBox="1"/>
          <p:nvPr/>
        </p:nvSpPr>
        <p:spPr>
          <a:xfrm rot="18900000">
            <a:off x="1627047" y="472848"/>
            <a:ext cx="327489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λ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435168D-CF67-9B16-C206-3381EC0F568D}"/>
              </a:ext>
            </a:extLst>
          </p:cNvPr>
          <p:cNvSpPr txBox="1"/>
          <p:nvPr/>
        </p:nvSpPr>
        <p:spPr>
          <a:xfrm>
            <a:off x="812099" y="272311"/>
            <a:ext cx="364584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0B4C011-D2C8-24A3-2007-75DE66C2BDEF}"/>
              </a:ext>
            </a:extLst>
          </p:cNvPr>
          <p:cNvSpPr txBox="1"/>
          <p:nvPr/>
        </p:nvSpPr>
        <p:spPr>
          <a:xfrm>
            <a:off x="321155" y="526665"/>
            <a:ext cx="200055" cy="1184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9540CC0-05AB-DBAE-7D98-57D7336C7125}"/>
              </a:ext>
            </a:extLst>
          </p:cNvPr>
          <p:cNvSpPr txBox="1"/>
          <p:nvPr/>
        </p:nvSpPr>
        <p:spPr>
          <a:xfrm>
            <a:off x="318723" y="693384"/>
            <a:ext cx="31159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431075B-F0EE-96A1-E799-4B15A11B0A29}"/>
              </a:ext>
            </a:extLst>
          </p:cNvPr>
          <p:cNvCxnSpPr/>
          <p:nvPr/>
        </p:nvCxnSpPr>
        <p:spPr>
          <a:xfrm>
            <a:off x="610725" y="790597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CD41334D-5DDF-A345-C29A-52A2CF2691F2}"/>
              </a:ext>
            </a:extLst>
          </p:cNvPr>
          <p:cNvSpPr txBox="1"/>
          <p:nvPr/>
        </p:nvSpPr>
        <p:spPr>
          <a:xfrm>
            <a:off x="318723" y="1086859"/>
            <a:ext cx="31159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A6D4C30-1958-6D97-24B1-4C8A36926630}"/>
              </a:ext>
            </a:extLst>
          </p:cNvPr>
          <p:cNvCxnSpPr/>
          <p:nvPr/>
        </p:nvCxnSpPr>
        <p:spPr>
          <a:xfrm>
            <a:off x="610725" y="1184072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8009CAF0-2EDA-7864-A694-CCFFB998EDAA}"/>
              </a:ext>
            </a:extLst>
          </p:cNvPr>
          <p:cNvSpPr txBox="1"/>
          <p:nvPr/>
        </p:nvSpPr>
        <p:spPr>
          <a:xfrm>
            <a:off x="368796" y="1459221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676D43C-0EDC-DB0C-50C8-C0E74FB7D200}"/>
              </a:ext>
            </a:extLst>
          </p:cNvPr>
          <p:cNvCxnSpPr/>
          <p:nvPr/>
        </p:nvCxnSpPr>
        <p:spPr>
          <a:xfrm>
            <a:off x="614189" y="1563786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EE3EF6FB-5A9A-7AA3-0DC9-D49FD1D28554}"/>
              </a:ext>
            </a:extLst>
          </p:cNvPr>
          <p:cNvSpPr txBox="1"/>
          <p:nvPr/>
        </p:nvSpPr>
        <p:spPr>
          <a:xfrm>
            <a:off x="1838277" y="803745"/>
            <a:ext cx="229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9E9BC83-90EE-D346-C2A2-23CCA094AD33}"/>
              </a:ext>
            </a:extLst>
          </p:cNvPr>
          <p:cNvSpPr txBox="1"/>
          <p:nvPr/>
        </p:nvSpPr>
        <p:spPr>
          <a:xfrm>
            <a:off x="610556" y="1636815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EEFCECE2-E0CA-C93F-E16E-310E17FC609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" t="779" r="167" b="-156"/>
          <a:stretch/>
        </p:blipFill>
        <p:spPr>
          <a:xfrm rot="16200000">
            <a:off x="2560780" y="766961"/>
            <a:ext cx="4118486" cy="31291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7488DBC8-DEA8-DDDD-5F39-A8342EC570A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3" t="403" r="-716" b="522"/>
          <a:stretch/>
        </p:blipFill>
        <p:spPr>
          <a:xfrm rot="16200000">
            <a:off x="6478749" y="104117"/>
            <a:ext cx="3235005" cy="35270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DA952320-33C8-93E6-E73A-599FC8E4D5BD}"/>
              </a:ext>
            </a:extLst>
          </p:cNvPr>
          <p:cNvSpPr/>
          <p:nvPr/>
        </p:nvSpPr>
        <p:spPr>
          <a:xfrm>
            <a:off x="3811110" y="1014833"/>
            <a:ext cx="332056" cy="2689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49A2124A-86CD-50D8-2B6F-83FE9B632979}"/>
              </a:ext>
            </a:extLst>
          </p:cNvPr>
          <p:cNvSpPr/>
          <p:nvPr/>
        </p:nvSpPr>
        <p:spPr>
          <a:xfrm>
            <a:off x="5091635" y="968362"/>
            <a:ext cx="332056" cy="2689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A6580B93-93AC-A13F-E648-15B68C899D87}"/>
              </a:ext>
            </a:extLst>
          </p:cNvPr>
          <p:cNvSpPr/>
          <p:nvPr/>
        </p:nvSpPr>
        <p:spPr>
          <a:xfrm>
            <a:off x="6891810" y="833876"/>
            <a:ext cx="332056" cy="2689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D9A5FE16-8830-E326-874F-4B5B2C60B4DA}"/>
              </a:ext>
            </a:extLst>
          </p:cNvPr>
          <p:cNvSpPr/>
          <p:nvPr/>
        </p:nvSpPr>
        <p:spPr>
          <a:xfrm>
            <a:off x="7223866" y="1890541"/>
            <a:ext cx="332056" cy="2689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CC409910-CE03-19B8-CD0E-D8129BDEE05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8" t="261" r="532" b="655"/>
          <a:stretch/>
        </p:blipFill>
        <p:spPr>
          <a:xfrm rot="16200000">
            <a:off x="244944" y="3314953"/>
            <a:ext cx="3186664" cy="35270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Rectangle 36">
            <a:extLst>
              <a:ext uri="{FF2B5EF4-FFF2-40B4-BE49-F238E27FC236}">
                <a16:creationId xmlns:a16="http://schemas.microsoft.com/office/drawing/2014/main" id="{BA2911C7-CA33-D604-677A-6851318822A8}"/>
              </a:ext>
            </a:extLst>
          </p:cNvPr>
          <p:cNvSpPr/>
          <p:nvPr/>
        </p:nvSpPr>
        <p:spPr>
          <a:xfrm>
            <a:off x="646071" y="4390799"/>
            <a:ext cx="332056" cy="2689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72EEB21A-6FC5-EA8E-1157-94920F9F23CB}"/>
              </a:ext>
            </a:extLst>
          </p:cNvPr>
          <p:cNvSpPr/>
          <p:nvPr/>
        </p:nvSpPr>
        <p:spPr>
          <a:xfrm>
            <a:off x="967366" y="5502493"/>
            <a:ext cx="332056" cy="2689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675D900-4D0A-C26C-EEC9-79000B4E9CD4}"/>
              </a:ext>
            </a:extLst>
          </p:cNvPr>
          <p:cNvSpPr txBox="1"/>
          <p:nvPr/>
        </p:nvSpPr>
        <p:spPr>
          <a:xfrm>
            <a:off x="3711660" y="503143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Ser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E1B446B-CA34-08DB-8DF4-61608A6CCFB2}"/>
              </a:ext>
            </a:extLst>
          </p:cNvPr>
          <p:cNvSpPr txBox="1"/>
          <p:nvPr/>
        </p:nvSpPr>
        <p:spPr>
          <a:xfrm>
            <a:off x="4948139" y="549829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Ser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40C6C58-F57C-C3E9-9829-96AEF1843146}"/>
              </a:ext>
            </a:extLst>
          </p:cNvPr>
          <p:cNvSpPr txBox="1"/>
          <p:nvPr/>
        </p:nvSpPr>
        <p:spPr>
          <a:xfrm>
            <a:off x="6270720" y="892722"/>
            <a:ext cx="45467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B3574B2-7DA8-728C-8C90-267E79A66B13}"/>
              </a:ext>
            </a:extLst>
          </p:cNvPr>
          <p:cNvSpPr txBox="1"/>
          <p:nvPr/>
        </p:nvSpPr>
        <p:spPr>
          <a:xfrm>
            <a:off x="7114851" y="1683951"/>
            <a:ext cx="45467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F5A4682-7B83-2A49-D45A-48A9CCC8E060}"/>
              </a:ext>
            </a:extLst>
          </p:cNvPr>
          <p:cNvSpPr txBox="1"/>
          <p:nvPr/>
        </p:nvSpPr>
        <p:spPr>
          <a:xfrm>
            <a:off x="552660" y="4193779"/>
            <a:ext cx="428174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DA50533-6B24-32AA-6040-D60CD836F499}"/>
              </a:ext>
            </a:extLst>
          </p:cNvPr>
          <p:cNvSpPr txBox="1"/>
          <p:nvPr/>
        </p:nvSpPr>
        <p:spPr>
          <a:xfrm>
            <a:off x="1313726" y="5541593"/>
            <a:ext cx="428174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</p:spTree>
    <p:extLst>
      <p:ext uri="{BB962C8B-B14F-4D97-AF65-F5344CB8AC3E}">
        <p14:creationId xmlns:p14="http://schemas.microsoft.com/office/powerpoint/2010/main" val="23465898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F2B42A4-95F4-93F6-2DD5-998F45BB2B4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90" t="30460" r="16866" b="29782"/>
          <a:stretch/>
        </p:blipFill>
        <p:spPr>
          <a:xfrm rot="16200000">
            <a:off x="884292" y="190015"/>
            <a:ext cx="268238" cy="12294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983D65E-EF28-04FF-AD16-4C4FD5D0E6B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031" t="31003" r="27225" b="29239"/>
          <a:stretch/>
        </p:blipFill>
        <p:spPr>
          <a:xfrm rot="16200000">
            <a:off x="884292" y="1077867"/>
            <a:ext cx="268238" cy="12294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9598AAA-C23C-3E3A-52E8-0BA26F8EC94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247" t="33446" r="49009" b="26796"/>
          <a:stretch/>
        </p:blipFill>
        <p:spPr>
          <a:xfrm rot="16200000">
            <a:off x="2135044" y="190015"/>
            <a:ext cx="268238" cy="12294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E5CBE10-E58C-8812-155B-88FBD171FB9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81" t="52854" r="29264" b="26238"/>
          <a:stretch/>
        </p:blipFill>
        <p:spPr>
          <a:xfrm rot="16200000">
            <a:off x="2135044" y="1077631"/>
            <a:ext cx="268238" cy="12294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CBC3007-7BDC-E412-D576-CB85BB57775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51" t="55637" r="21094" b="23455"/>
          <a:stretch/>
        </p:blipFill>
        <p:spPr>
          <a:xfrm rot="16200000">
            <a:off x="884292" y="485966"/>
            <a:ext cx="268238" cy="12294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0C7E978-C275-AE61-6DB0-68859CF2650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821" t="56490" r="51524" b="22602"/>
          <a:stretch/>
        </p:blipFill>
        <p:spPr>
          <a:xfrm rot="16200000">
            <a:off x="2135044" y="485966"/>
            <a:ext cx="268238" cy="12294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4A3F936-252E-CDB6-8CC1-7CB7D5CB5A9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188" t="17716" r="23059" b="40056"/>
          <a:stretch/>
        </p:blipFill>
        <p:spPr>
          <a:xfrm rot="16200000">
            <a:off x="884292" y="781917"/>
            <a:ext cx="268238" cy="12294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8543078-9212-ABC7-3046-B787F24C0BF8}"/>
              </a:ext>
            </a:extLst>
          </p:cNvPr>
          <p:cNvSpPr txBox="1"/>
          <p:nvPr/>
        </p:nvSpPr>
        <p:spPr>
          <a:xfrm>
            <a:off x="572488" y="433857"/>
            <a:ext cx="146514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168D637-B93A-2658-FBD2-F8240893347B}"/>
              </a:ext>
            </a:extLst>
          </p:cNvPr>
          <p:cNvSpPr txBox="1"/>
          <p:nvPr/>
        </p:nvSpPr>
        <p:spPr>
          <a:xfrm>
            <a:off x="685726" y="433857"/>
            <a:ext cx="170402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19AEFDA-E852-09C1-B73E-26A3854783C8}"/>
              </a:ext>
            </a:extLst>
          </p:cNvPr>
          <p:cNvSpPr txBox="1"/>
          <p:nvPr/>
        </p:nvSpPr>
        <p:spPr>
          <a:xfrm>
            <a:off x="136151" y="700209"/>
            <a:ext cx="234103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BB2A0A6-5561-D6DB-5298-76CE92CF6EE5}"/>
              </a:ext>
            </a:extLst>
          </p:cNvPr>
          <p:cNvSpPr txBox="1"/>
          <p:nvPr/>
        </p:nvSpPr>
        <p:spPr>
          <a:xfrm>
            <a:off x="175964" y="1009248"/>
            <a:ext cx="194290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77C14F7-1CA5-D5EB-06E8-EC2D82ADAF96}"/>
              </a:ext>
            </a:extLst>
          </p:cNvPr>
          <p:cNvSpPr txBox="1"/>
          <p:nvPr/>
        </p:nvSpPr>
        <p:spPr>
          <a:xfrm>
            <a:off x="175964" y="1274174"/>
            <a:ext cx="194290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A0EED86-2FB1-9AA2-6EFD-29CE65BAF492}"/>
              </a:ext>
            </a:extLst>
          </p:cNvPr>
          <p:cNvSpPr txBox="1"/>
          <p:nvPr/>
        </p:nvSpPr>
        <p:spPr>
          <a:xfrm>
            <a:off x="0" y="454620"/>
            <a:ext cx="242066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04A3287-FF3D-FA75-7724-A57431049013}"/>
              </a:ext>
            </a:extLst>
          </p:cNvPr>
          <p:cNvSpPr txBox="1"/>
          <p:nvPr/>
        </p:nvSpPr>
        <p:spPr>
          <a:xfrm>
            <a:off x="757668" y="180736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0997A70-2692-5248-7D25-6D0240091F53}"/>
              </a:ext>
            </a:extLst>
          </p:cNvPr>
          <p:cNvSpPr txBox="1"/>
          <p:nvPr/>
        </p:nvSpPr>
        <p:spPr>
          <a:xfrm>
            <a:off x="868676" y="433857"/>
            <a:ext cx="146514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E01FB7E-BD83-E90E-5D1F-4E8028ACD28E}"/>
              </a:ext>
            </a:extLst>
          </p:cNvPr>
          <p:cNvSpPr txBox="1"/>
          <p:nvPr/>
        </p:nvSpPr>
        <p:spPr>
          <a:xfrm>
            <a:off x="1032716" y="433857"/>
            <a:ext cx="170402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071D7C1-BBA2-875B-D2FF-FDB979E66049}"/>
              </a:ext>
            </a:extLst>
          </p:cNvPr>
          <p:cNvSpPr txBox="1"/>
          <p:nvPr/>
        </p:nvSpPr>
        <p:spPr>
          <a:xfrm>
            <a:off x="1215666" y="433857"/>
            <a:ext cx="146514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ABA64C0-845A-5B3D-9730-27B50F8D5D2A}"/>
              </a:ext>
            </a:extLst>
          </p:cNvPr>
          <p:cNvSpPr txBox="1"/>
          <p:nvPr/>
        </p:nvSpPr>
        <p:spPr>
          <a:xfrm>
            <a:off x="1379704" y="433857"/>
            <a:ext cx="170402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B409D77-9EC6-3815-106C-26B85956DD66}"/>
              </a:ext>
            </a:extLst>
          </p:cNvPr>
          <p:cNvSpPr txBox="1"/>
          <p:nvPr/>
        </p:nvSpPr>
        <p:spPr>
          <a:xfrm>
            <a:off x="350051" y="151758"/>
            <a:ext cx="4963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eLa W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792E627-CA98-FE86-C80C-FB93B5496CA4}"/>
              </a:ext>
            </a:extLst>
          </p:cNvPr>
          <p:cNvSpPr txBox="1"/>
          <p:nvPr/>
        </p:nvSpPr>
        <p:spPr>
          <a:xfrm>
            <a:off x="761254" y="151758"/>
            <a:ext cx="5823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A81EAC4-C1AC-441E-8D2E-4E16535E5D66}"/>
              </a:ext>
            </a:extLst>
          </p:cNvPr>
          <p:cNvSpPr txBox="1"/>
          <p:nvPr/>
        </p:nvSpPr>
        <p:spPr>
          <a:xfrm>
            <a:off x="1150705" y="151758"/>
            <a:ext cx="4999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9FF6DCFA-F051-C9A9-9322-086D1C4F78C3}"/>
              </a:ext>
            </a:extLst>
          </p:cNvPr>
          <p:cNvCxnSpPr/>
          <p:nvPr/>
        </p:nvCxnSpPr>
        <p:spPr>
          <a:xfrm>
            <a:off x="438951" y="450414"/>
            <a:ext cx="35074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D4E7D48-1A05-317B-A05C-1E91B65182B2}"/>
              </a:ext>
            </a:extLst>
          </p:cNvPr>
          <p:cNvCxnSpPr/>
          <p:nvPr/>
        </p:nvCxnSpPr>
        <p:spPr>
          <a:xfrm>
            <a:off x="898489" y="450414"/>
            <a:ext cx="2635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999B1E62-B7D9-DE36-2E78-409B2EE42CE9}"/>
              </a:ext>
            </a:extLst>
          </p:cNvPr>
          <p:cNvCxnSpPr/>
          <p:nvPr/>
        </p:nvCxnSpPr>
        <p:spPr>
          <a:xfrm>
            <a:off x="1247944" y="450414"/>
            <a:ext cx="2635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9F59B036-AC03-B990-CBA5-8C7F8CE8BF55}"/>
              </a:ext>
            </a:extLst>
          </p:cNvPr>
          <p:cNvSpPr txBox="1"/>
          <p:nvPr/>
        </p:nvSpPr>
        <p:spPr>
          <a:xfrm>
            <a:off x="175964" y="1592634"/>
            <a:ext cx="194290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2F5DEC6-3A70-CF3F-698E-3D2D1405ED2C}"/>
              </a:ext>
            </a:extLst>
          </p:cNvPr>
          <p:cNvSpPr txBox="1"/>
          <p:nvPr/>
        </p:nvSpPr>
        <p:spPr>
          <a:xfrm>
            <a:off x="324309" y="451583"/>
            <a:ext cx="230122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D2A412C-E10E-717D-B0E3-EEE3538A35FE}"/>
              </a:ext>
            </a:extLst>
          </p:cNvPr>
          <p:cNvSpPr txBox="1"/>
          <p:nvPr/>
        </p:nvSpPr>
        <p:spPr>
          <a:xfrm>
            <a:off x="1820516" y="433858"/>
            <a:ext cx="146514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CD87CD5-3A92-6128-EB16-1E52CF6E9157}"/>
              </a:ext>
            </a:extLst>
          </p:cNvPr>
          <p:cNvSpPr txBox="1"/>
          <p:nvPr/>
        </p:nvSpPr>
        <p:spPr>
          <a:xfrm>
            <a:off x="1940105" y="433858"/>
            <a:ext cx="170402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11062E8-C91F-275E-16E9-7181D04429DC}"/>
              </a:ext>
            </a:extLst>
          </p:cNvPr>
          <p:cNvSpPr txBox="1"/>
          <p:nvPr/>
        </p:nvSpPr>
        <p:spPr>
          <a:xfrm>
            <a:off x="1952996" y="1810415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IP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E983A4E-9DF3-A4B0-59A2-F25BFD678145}"/>
              </a:ext>
            </a:extLst>
          </p:cNvPr>
          <p:cNvSpPr txBox="1"/>
          <p:nvPr/>
        </p:nvSpPr>
        <p:spPr>
          <a:xfrm>
            <a:off x="2123055" y="433858"/>
            <a:ext cx="146514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BE6C6ED-867A-BC1B-B17A-F61596B2BDF0}"/>
              </a:ext>
            </a:extLst>
          </p:cNvPr>
          <p:cNvSpPr txBox="1"/>
          <p:nvPr/>
        </p:nvSpPr>
        <p:spPr>
          <a:xfrm>
            <a:off x="2287094" y="433858"/>
            <a:ext cx="170402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E546E59-F07A-0CE8-F5BB-7A81218DFA93}"/>
              </a:ext>
            </a:extLst>
          </p:cNvPr>
          <p:cNvSpPr txBox="1"/>
          <p:nvPr/>
        </p:nvSpPr>
        <p:spPr>
          <a:xfrm>
            <a:off x="2470044" y="433858"/>
            <a:ext cx="146514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587B54D-2995-9E19-445B-2577A3D956E0}"/>
              </a:ext>
            </a:extLst>
          </p:cNvPr>
          <p:cNvSpPr txBox="1"/>
          <p:nvPr/>
        </p:nvSpPr>
        <p:spPr>
          <a:xfrm>
            <a:off x="2634082" y="433858"/>
            <a:ext cx="170402" cy="171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54E431B-1FD2-B9AF-B2F8-FEC6E41DDC64}"/>
              </a:ext>
            </a:extLst>
          </p:cNvPr>
          <p:cNvSpPr txBox="1"/>
          <p:nvPr/>
        </p:nvSpPr>
        <p:spPr>
          <a:xfrm>
            <a:off x="1604429" y="151758"/>
            <a:ext cx="5130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eLa W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5032B5E-55F8-022F-96E5-783457177BD3}"/>
              </a:ext>
            </a:extLst>
          </p:cNvPr>
          <p:cNvSpPr txBox="1"/>
          <p:nvPr/>
        </p:nvSpPr>
        <p:spPr>
          <a:xfrm>
            <a:off x="2015633" y="151758"/>
            <a:ext cx="5100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2B98032-628D-78A1-0FB0-AF8C2F771A4A}"/>
              </a:ext>
            </a:extLst>
          </p:cNvPr>
          <p:cNvSpPr txBox="1"/>
          <p:nvPr/>
        </p:nvSpPr>
        <p:spPr>
          <a:xfrm>
            <a:off x="2405083" y="151758"/>
            <a:ext cx="5164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2C010EC6-8B6C-B0DD-F8A5-9DF9BDBC8D96}"/>
              </a:ext>
            </a:extLst>
          </p:cNvPr>
          <p:cNvCxnSpPr/>
          <p:nvPr/>
        </p:nvCxnSpPr>
        <p:spPr>
          <a:xfrm>
            <a:off x="1693329" y="450414"/>
            <a:ext cx="35074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67F95097-A6FD-6E91-662C-82318F56195F}"/>
              </a:ext>
            </a:extLst>
          </p:cNvPr>
          <p:cNvCxnSpPr/>
          <p:nvPr/>
        </p:nvCxnSpPr>
        <p:spPr>
          <a:xfrm>
            <a:off x="2152868" y="450414"/>
            <a:ext cx="2635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76268549-3B7E-940A-8F2E-65B60613A05E}"/>
              </a:ext>
            </a:extLst>
          </p:cNvPr>
          <p:cNvCxnSpPr/>
          <p:nvPr/>
        </p:nvCxnSpPr>
        <p:spPr>
          <a:xfrm>
            <a:off x="2502322" y="450414"/>
            <a:ext cx="2635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A4418125-B658-2400-18CC-D5EC5F6A3FD0}"/>
              </a:ext>
            </a:extLst>
          </p:cNvPr>
          <p:cNvSpPr txBox="1"/>
          <p:nvPr/>
        </p:nvSpPr>
        <p:spPr>
          <a:xfrm>
            <a:off x="2858969" y="700470"/>
            <a:ext cx="341600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41A612A-19E3-5587-8EA3-DC239C4BF36D}"/>
              </a:ext>
            </a:extLst>
          </p:cNvPr>
          <p:cNvSpPr txBox="1"/>
          <p:nvPr/>
        </p:nvSpPr>
        <p:spPr>
          <a:xfrm>
            <a:off x="2858969" y="1290174"/>
            <a:ext cx="334633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AEEC443-EE4C-3541-FA72-F9AEA80D7DB1}"/>
              </a:ext>
            </a:extLst>
          </p:cNvPr>
          <p:cNvSpPr txBox="1"/>
          <p:nvPr/>
        </p:nvSpPr>
        <p:spPr>
          <a:xfrm>
            <a:off x="2861536" y="1561364"/>
            <a:ext cx="321694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DA54DD3-B2FD-E56F-A5A7-55945F5A514C}"/>
              </a:ext>
            </a:extLst>
          </p:cNvPr>
          <p:cNvSpPr txBox="1"/>
          <p:nvPr/>
        </p:nvSpPr>
        <p:spPr>
          <a:xfrm>
            <a:off x="2858969" y="987234"/>
            <a:ext cx="335628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E4F0180-1A0B-20DB-A3D8-F4A60F828F0F}"/>
              </a:ext>
            </a:extLst>
          </p:cNvPr>
          <p:cNvSpPr txBox="1"/>
          <p:nvPr/>
        </p:nvSpPr>
        <p:spPr>
          <a:xfrm>
            <a:off x="1564141" y="448189"/>
            <a:ext cx="230122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79308954-533F-F76F-BB89-0F2C89F9272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81" t="53878" r="51642" b="21816"/>
          <a:stretch/>
        </p:blipFill>
        <p:spPr>
          <a:xfrm rot="16200000">
            <a:off x="2135044" y="781917"/>
            <a:ext cx="268239" cy="122942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2BE2748B-6B5C-29F7-7E54-A20C778007DF}"/>
              </a:ext>
            </a:extLst>
          </p:cNvPr>
          <p:cNvCxnSpPr>
            <a:cxnSpLocks/>
          </p:cNvCxnSpPr>
          <p:nvPr/>
        </p:nvCxnSpPr>
        <p:spPr>
          <a:xfrm>
            <a:off x="304254" y="1703548"/>
            <a:ext cx="560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443C93A5-DE8C-530A-D1BC-FB002A217FEF}"/>
              </a:ext>
            </a:extLst>
          </p:cNvPr>
          <p:cNvCxnSpPr>
            <a:cxnSpLocks/>
          </p:cNvCxnSpPr>
          <p:nvPr/>
        </p:nvCxnSpPr>
        <p:spPr>
          <a:xfrm>
            <a:off x="311854" y="813674"/>
            <a:ext cx="560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674B3BE1-0D45-CFDD-0B63-95E82E99D506}"/>
              </a:ext>
            </a:extLst>
          </p:cNvPr>
          <p:cNvCxnSpPr>
            <a:cxnSpLocks/>
          </p:cNvCxnSpPr>
          <p:nvPr/>
        </p:nvCxnSpPr>
        <p:spPr>
          <a:xfrm>
            <a:off x="311854" y="1133010"/>
            <a:ext cx="560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CC61DDFF-0811-B46A-AB4D-9F2371A37EED}"/>
              </a:ext>
            </a:extLst>
          </p:cNvPr>
          <p:cNvCxnSpPr>
            <a:cxnSpLocks/>
          </p:cNvCxnSpPr>
          <p:nvPr/>
        </p:nvCxnSpPr>
        <p:spPr>
          <a:xfrm>
            <a:off x="311854" y="1387273"/>
            <a:ext cx="560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7577DB2E-B337-50F4-B74D-60EE2AC31766}"/>
              </a:ext>
            </a:extLst>
          </p:cNvPr>
          <p:cNvSpPr txBox="1"/>
          <p:nvPr/>
        </p:nvSpPr>
        <p:spPr>
          <a:xfrm>
            <a:off x="2839919" y="443412"/>
            <a:ext cx="364493" cy="152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72211A5-34BD-8992-48E4-68E65E0D9359}"/>
              </a:ext>
            </a:extLst>
          </p:cNvPr>
          <p:cNvSpPr txBox="1"/>
          <p:nvPr/>
        </p:nvSpPr>
        <p:spPr>
          <a:xfrm>
            <a:off x="-12854" y="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071510E5-9A6C-DE0C-82E0-6D220C7E2A0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9" t="-96" r="523" b="423"/>
          <a:stretch/>
        </p:blipFill>
        <p:spPr>
          <a:xfrm rot="16200000">
            <a:off x="2823204" y="870154"/>
            <a:ext cx="3176589" cy="17397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5" name="Rectangle 54">
            <a:extLst>
              <a:ext uri="{FF2B5EF4-FFF2-40B4-BE49-F238E27FC236}">
                <a16:creationId xmlns:a16="http://schemas.microsoft.com/office/drawing/2014/main" id="{5D16455F-6C77-DF9F-6ED6-31AC8AD22363}"/>
              </a:ext>
            </a:extLst>
          </p:cNvPr>
          <p:cNvSpPr/>
          <p:nvPr/>
        </p:nvSpPr>
        <p:spPr>
          <a:xfrm>
            <a:off x="4061766" y="657076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EDE8AD92-6223-B11F-75B0-5B8C3CB24713}"/>
              </a:ext>
            </a:extLst>
          </p:cNvPr>
          <p:cNvSpPr/>
          <p:nvPr/>
        </p:nvSpPr>
        <p:spPr>
          <a:xfrm>
            <a:off x="4099364" y="1686675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2468AA9C-E906-41A6-FC37-512502A6008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6" t="1147" r="-637" b="1016"/>
          <a:stretch/>
        </p:blipFill>
        <p:spPr>
          <a:xfrm rot="16200000">
            <a:off x="5454791" y="131688"/>
            <a:ext cx="3233778" cy="3247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8" name="Rectangle 57">
            <a:extLst>
              <a:ext uri="{FF2B5EF4-FFF2-40B4-BE49-F238E27FC236}">
                <a16:creationId xmlns:a16="http://schemas.microsoft.com/office/drawing/2014/main" id="{69BAAE0F-4A93-4529-C263-917CBC039633}"/>
              </a:ext>
            </a:extLst>
          </p:cNvPr>
          <p:cNvSpPr/>
          <p:nvPr/>
        </p:nvSpPr>
        <p:spPr>
          <a:xfrm>
            <a:off x="7272891" y="818108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D39BEBA8-690B-C788-9D9A-ADE18DC39576}"/>
              </a:ext>
            </a:extLst>
          </p:cNvPr>
          <p:cNvSpPr/>
          <p:nvPr/>
        </p:nvSpPr>
        <p:spPr>
          <a:xfrm>
            <a:off x="7272891" y="1826463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0" name="Picture 59">
            <a:extLst>
              <a:ext uri="{FF2B5EF4-FFF2-40B4-BE49-F238E27FC236}">
                <a16:creationId xmlns:a16="http://schemas.microsoft.com/office/drawing/2014/main" id="{A20A459C-E37D-BB33-EC10-0196631D154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1" t="-1386" r="441" b="1600"/>
          <a:stretch/>
        </p:blipFill>
        <p:spPr>
          <a:xfrm rot="16200000">
            <a:off x="8145242" y="931691"/>
            <a:ext cx="3153429" cy="163988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1" name="Rectangle 60">
            <a:extLst>
              <a:ext uri="{FF2B5EF4-FFF2-40B4-BE49-F238E27FC236}">
                <a16:creationId xmlns:a16="http://schemas.microsoft.com/office/drawing/2014/main" id="{C5706B6D-684D-C9E4-138B-B1416AC6BFD6}"/>
              </a:ext>
            </a:extLst>
          </p:cNvPr>
          <p:cNvSpPr/>
          <p:nvPr/>
        </p:nvSpPr>
        <p:spPr>
          <a:xfrm>
            <a:off x="9171143" y="855341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E0D7D033-164F-18EC-E56B-C47817DB624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4" t="831" r="-426" b="387"/>
          <a:stretch/>
        </p:blipFill>
        <p:spPr>
          <a:xfrm rot="16200000">
            <a:off x="667057" y="3169137"/>
            <a:ext cx="1940959" cy="28204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3" name="Rectangle 62">
            <a:extLst>
              <a:ext uri="{FF2B5EF4-FFF2-40B4-BE49-F238E27FC236}">
                <a16:creationId xmlns:a16="http://schemas.microsoft.com/office/drawing/2014/main" id="{F0C7E813-7164-0E0B-DB14-DD0467725517}"/>
              </a:ext>
            </a:extLst>
          </p:cNvPr>
          <p:cNvSpPr/>
          <p:nvPr/>
        </p:nvSpPr>
        <p:spPr>
          <a:xfrm>
            <a:off x="1745704" y="4639565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88DA44EC-A087-60F5-FAFA-EB5320328E6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6" t="-940" r="-350" b="-87"/>
          <a:stretch/>
        </p:blipFill>
        <p:spPr>
          <a:xfrm rot="16200000">
            <a:off x="3320071" y="4185346"/>
            <a:ext cx="3537385" cy="19397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C6758C4C-DEE6-2F73-0A48-33DD727833F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76" t="-64" r="-423" b="145"/>
          <a:stretch/>
        </p:blipFill>
        <p:spPr>
          <a:xfrm rot="16200000">
            <a:off x="7137305" y="3522130"/>
            <a:ext cx="3301468" cy="33165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6" name="Rectangle 65">
            <a:extLst>
              <a:ext uri="{FF2B5EF4-FFF2-40B4-BE49-F238E27FC236}">
                <a16:creationId xmlns:a16="http://schemas.microsoft.com/office/drawing/2014/main" id="{F285548C-193F-69A2-AA05-7C78896F525C}"/>
              </a:ext>
            </a:extLst>
          </p:cNvPr>
          <p:cNvSpPr/>
          <p:nvPr/>
        </p:nvSpPr>
        <p:spPr>
          <a:xfrm>
            <a:off x="4703044" y="4329964"/>
            <a:ext cx="782971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ED4BE4C3-EF6E-0C84-9DF5-B1B97D021266}"/>
              </a:ext>
            </a:extLst>
          </p:cNvPr>
          <p:cNvSpPr/>
          <p:nvPr/>
        </p:nvSpPr>
        <p:spPr>
          <a:xfrm>
            <a:off x="8796786" y="4495840"/>
            <a:ext cx="782971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10FEEFBA-B2C6-56D7-E289-7764D4133A96}"/>
              </a:ext>
            </a:extLst>
          </p:cNvPr>
          <p:cNvSpPr txBox="1"/>
          <p:nvPr/>
        </p:nvSpPr>
        <p:spPr>
          <a:xfrm>
            <a:off x="4761440" y="795517"/>
            <a:ext cx="341600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0D90E9E-8C70-856A-CEB4-F6640CA40BF1}"/>
              </a:ext>
            </a:extLst>
          </p:cNvPr>
          <p:cNvSpPr txBox="1"/>
          <p:nvPr/>
        </p:nvSpPr>
        <p:spPr>
          <a:xfrm>
            <a:off x="4361444" y="1442586"/>
            <a:ext cx="341600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BDC23B9-5930-354D-D818-B1E6CCD6D8F4}"/>
              </a:ext>
            </a:extLst>
          </p:cNvPr>
          <p:cNvSpPr txBox="1"/>
          <p:nvPr/>
        </p:nvSpPr>
        <p:spPr>
          <a:xfrm>
            <a:off x="8035855" y="813674"/>
            <a:ext cx="335628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AFCF80E-D422-857B-04A0-CAECBF278F98}"/>
              </a:ext>
            </a:extLst>
          </p:cNvPr>
          <p:cNvSpPr txBox="1"/>
          <p:nvPr/>
        </p:nvSpPr>
        <p:spPr>
          <a:xfrm>
            <a:off x="8004403" y="1862482"/>
            <a:ext cx="335628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7A51B88-FD4B-68BC-C771-1CE81F891921}"/>
              </a:ext>
            </a:extLst>
          </p:cNvPr>
          <p:cNvSpPr txBox="1"/>
          <p:nvPr/>
        </p:nvSpPr>
        <p:spPr>
          <a:xfrm>
            <a:off x="9984747" y="823229"/>
            <a:ext cx="334633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77FCCA1-DA76-BC24-2720-B1BA0A4FDF80}"/>
              </a:ext>
            </a:extLst>
          </p:cNvPr>
          <p:cNvSpPr txBox="1"/>
          <p:nvPr/>
        </p:nvSpPr>
        <p:spPr>
          <a:xfrm>
            <a:off x="2023436" y="4373773"/>
            <a:ext cx="334633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77D2F6C-EFB7-1BA3-42D8-00E7E6B7C2DD}"/>
              </a:ext>
            </a:extLst>
          </p:cNvPr>
          <p:cNvSpPr txBox="1"/>
          <p:nvPr/>
        </p:nvSpPr>
        <p:spPr>
          <a:xfrm>
            <a:off x="4600593" y="4567900"/>
            <a:ext cx="321694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60FBC7E-81B9-4594-E20D-5500919E73D3}"/>
              </a:ext>
            </a:extLst>
          </p:cNvPr>
          <p:cNvSpPr txBox="1"/>
          <p:nvPr/>
        </p:nvSpPr>
        <p:spPr>
          <a:xfrm>
            <a:off x="9509522" y="4457169"/>
            <a:ext cx="321694" cy="143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</p:spTree>
    <p:extLst>
      <p:ext uri="{BB962C8B-B14F-4D97-AF65-F5344CB8AC3E}">
        <p14:creationId xmlns:p14="http://schemas.microsoft.com/office/powerpoint/2010/main" val="27555021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0475E35-5DE5-5313-2FC9-0029B2D19817}"/>
              </a:ext>
            </a:extLst>
          </p:cNvPr>
          <p:cNvSpPr txBox="1"/>
          <p:nvPr/>
        </p:nvSpPr>
        <p:spPr>
          <a:xfrm>
            <a:off x="1113764" y="435854"/>
            <a:ext cx="72492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siRN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26BC36D-D22C-8F6F-74E4-A848C28D5651}"/>
              </a:ext>
            </a:extLst>
          </p:cNvPr>
          <p:cNvSpPr txBox="1"/>
          <p:nvPr/>
        </p:nvSpPr>
        <p:spPr>
          <a:xfrm>
            <a:off x="474715" y="425042"/>
            <a:ext cx="184412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3CAAACF-E44C-BDFD-D9F8-1EC41F207DBF}"/>
              </a:ext>
            </a:extLst>
          </p:cNvPr>
          <p:cNvSpPr txBox="1"/>
          <p:nvPr/>
        </p:nvSpPr>
        <p:spPr>
          <a:xfrm>
            <a:off x="624198" y="425042"/>
            <a:ext cx="20825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4C36018-2934-A7E8-AB21-7836FD1357EA}"/>
              </a:ext>
            </a:extLst>
          </p:cNvPr>
          <p:cNvSpPr txBox="1"/>
          <p:nvPr/>
        </p:nvSpPr>
        <p:spPr>
          <a:xfrm>
            <a:off x="790874" y="425042"/>
            <a:ext cx="184412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E5A488-0B13-518E-B05B-20BF1CCEEE3D}"/>
              </a:ext>
            </a:extLst>
          </p:cNvPr>
          <p:cNvSpPr txBox="1"/>
          <p:nvPr/>
        </p:nvSpPr>
        <p:spPr>
          <a:xfrm>
            <a:off x="940358" y="425042"/>
            <a:ext cx="20825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F218186-1EDC-D810-874C-E7BAA19F1363}"/>
              </a:ext>
            </a:extLst>
          </p:cNvPr>
          <p:cNvSpPr txBox="1"/>
          <p:nvPr/>
        </p:nvSpPr>
        <p:spPr>
          <a:xfrm>
            <a:off x="1115574" y="323246"/>
            <a:ext cx="453345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4EA7698-CB34-8EDE-BAB1-715BC0E19D2B}"/>
              </a:ext>
            </a:extLst>
          </p:cNvPr>
          <p:cNvSpPr txBox="1"/>
          <p:nvPr/>
        </p:nvSpPr>
        <p:spPr>
          <a:xfrm>
            <a:off x="474606" y="323246"/>
            <a:ext cx="184412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110B51C-9BDA-D406-213F-65B2C76C2CC2}"/>
              </a:ext>
            </a:extLst>
          </p:cNvPr>
          <p:cNvSpPr txBox="1"/>
          <p:nvPr/>
        </p:nvSpPr>
        <p:spPr>
          <a:xfrm>
            <a:off x="624089" y="323246"/>
            <a:ext cx="184412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DC06E9D-40B6-4F88-B23C-FD5C6DC81959}"/>
              </a:ext>
            </a:extLst>
          </p:cNvPr>
          <p:cNvSpPr txBox="1"/>
          <p:nvPr/>
        </p:nvSpPr>
        <p:spPr>
          <a:xfrm>
            <a:off x="790764" y="323246"/>
            <a:ext cx="20825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213EA76-D6FB-55B1-508A-780427EAB009}"/>
              </a:ext>
            </a:extLst>
          </p:cNvPr>
          <p:cNvSpPr txBox="1"/>
          <p:nvPr/>
        </p:nvSpPr>
        <p:spPr>
          <a:xfrm>
            <a:off x="940248" y="323246"/>
            <a:ext cx="20825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BCDF9E8-E26F-B659-6CCB-8E2AEDD50607}"/>
              </a:ext>
            </a:extLst>
          </p:cNvPr>
          <p:cNvSpPr txBox="1"/>
          <p:nvPr/>
        </p:nvSpPr>
        <p:spPr>
          <a:xfrm>
            <a:off x="1068887" y="1029087"/>
            <a:ext cx="33808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075080B-75E2-1169-794E-BD128B3406A8}"/>
              </a:ext>
            </a:extLst>
          </p:cNvPr>
          <p:cNvSpPr txBox="1"/>
          <p:nvPr/>
        </p:nvSpPr>
        <p:spPr>
          <a:xfrm>
            <a:off x="1068887" y="1703377"/>
            <a:ext cx="65074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PA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E455377-15BB-0B9A-C30D-F33889366953}"/>
              </a:ext>
            </a:extLst>
          </p:cNvPr>
          <p:cNvSpPr txBox="1"/>
          <p:nvPr/>
        </p:nvSpPr>
        <p:spPr>
          <a:xfrm>
            <a:off x="1068887" y="1910997"/>
            <a:ext cx="556563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F6AA320-5367-3C49-AF15-BD58ED8C2C9F}"/>
              </a:ext>
            </a:extLst>
          </p:cNvPr>
          <p:cNvSpPr txBox="1"/>
          <p:nvPr/>
        </p:nvSpPr>
        <p:spPr>
          <a:xfrm>
            <a:off x="422556" y="2032915"/>
            <a:ext cx="723275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9300DEAC-F4CB-F64B-CE00-65F8C0D4132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552" t="22209" r="42985" b="53157"/>
          <a:stretch/>
        </p:blipFill>
        <p:spPr>
          <a:xfrm rot="16200000">
            <a:off x="705260" y="1464129"/>
            <a:ext cx="196708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90D20FDB-B728-9414-4E62-B739ED41A6C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27" t="23905" r="30910" b="51461"/>
          <a:stretch/>
        </p:blipFill>
        <p:spPr>
          <a:xfrm rot="16200000">
            <a:off x="705260" y="834902"/>
            <a:ext cx="196708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5D14ACD-4A92-3DA9-EA1C-8F0127CDF32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997" t="30402" r="46528" b="46274"/>
          <a:stretch/>
        </p:blipFill>
        <p:spPr>
          <a:xfrm rot="16200000">
            <a:off x="705260" y="1673588"/>
            <a:ext cx="196708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B8BFF235-0AF6-20CC-D561-A4178541B766}"/>
              </a:ext>
            </a:extLst>
          </p:cNvPr>
          <p:cNvSpPr txBox="1"/>
          <p:nvPr/>
        </p:nvSpPr>
        <p:spPr>
          <a:xfrm>
            <a:off x="168820" y="351014"/>
            <a:ext cx="32219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5D08F394-9836-E61A-8A48-BAC877C5039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888" t="49059" r="14810" b="37046"/>
          <a:stretch/>
        </p:blipFill>
        <p:spPr>
          <a:xfrm rot="16200000">
            <a:off x="705260" y="625442"/>
            <a:ext cx="196708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2533020C-4083-BBDD-4ECE-8BC622A40DD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895" t="54365" r="14924" b="31896"/>
          <a:stretch/>
        </p:blipFill>
        <p:spPr>
          <a:xfrm rot="16200000">
            <a:off x="705260" y="415983"/>
            <a:ext cx="196708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6959F6E2-6CD1-BFED-544D-286250C67B35}"/>
              </a:ext>
            </a:extLst>
          </p:cNvPr>
          <p:cNvSpPr txBox="1"/>
          <p:nvPr/>
        </p:nvSpPr>
        <p:spPr>
          <a:xfrm>
            <a:off x="1068887" y="613708"/>
            <a:ext cx="45467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A32F211-9997-5EEF-E2A2-20AE37FDB08D}"/>
              </a:ext>
            </a:extLst>
          </p:cNvPr>
          <p:cNvSpPr txBox="1"/>
          <p:nvPr/>
        </p:nvSpPr>
        <p:spPr>
          <a:xfrm>
            <a:off x="1068887" y="823882"/>
            <a:ext cx="446721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682C2DC9-119E-B44F-6564-D34484EC206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390" t="13874" r="26548" b="73383"/>
          <a:stretch/>
        </p:blipFill>
        <p:spPr>
          <a:xfrm rot="16200000">
            <a:off x="706352" y="1045262"/>
            <a:ext cx="196708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E22185D8-4F64-A5A6-C96F-653027BC764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815" t="29526" r="26123" b="57731"/>
          <a:stretch/>
        </p:blipFill>
        <p:spPr>
          <a:xfrm rot="16200000">
            <a:off x="705260" y="1254695"/>
            <a:ext cx="196708" cy="5950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27057667-C8A2-4714-5614-67A3F4A2FBA9}"/>
              </a:ext>
            </a:extLst>
          </p:cNvPr>
          <p:cNvSpPr txBox="1"/>
          <p:nvPr/>
        </p:nvSpPr>
        <p:spPr>
          <a:xfrm>
            <a:off x="1068887" y="1451041"/>
            <a:ext cx="634842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zet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BA45386-53F7-E4CA-99BF-4BA5A98CF71B}"/>
              </a:ext>
            </a:extLst>
          </p:cNvPr>
          <p:cNvSpPr txBox="1"/>
          <p:nvPr/>
        </p:nvSpPr>
        <p:spPr>
          <a:xfrm>
            <a:off x="1068817" y="1225480"/>
            <a:ext cx="756723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epsilo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37D3489-AC18-C443-9567-5D2063689998}"/>
              </a:ext>
            </a:extLst>
          </p:cNvPr>
          <p:cNvSpPr txBox="1"/>
          <p:nvPr/>
        </p:nvSpPr>
        <p:spPr>
          <a:xfrm>
            <a:off x="103592" y="512291"/>
            <a:ext cx="311592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D8B561D-836C-4812-6465-F830E582562E}"/>
              </a:ext>
            </a:extLst>
          </p:cNvPr>
          <p:cNvSpPr txBox="1"/>
          <p:nvPr/>
        </p:nvSpPr>
        <p:spPr>
          <a:xfrm>
            <a:off x="157695" y="802818"/>
            <a:ext cx="194290" cy="1184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6670045-7908-42E6-6DDB-B040632F4FB8}"/>
              </a:ext>
            </a:extLst>
          </p:cNvPr>
          <p:cNvSpPr txBox="1"/>
          <p:nvPr/>
        </p:nvSpPr>
        <p:spPr>
          <a:xfrm>
            <a:off x="157695" y="1235975"/>
            <a:ext cx="25860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E2A6772-1EA2-C7A5-D8C0-5016EF2177A7}"/>
              </a:ext>
            </a:extLst>
          </p:cNvPr>
          <p:cNvSpPr txBox="1"/>
          <p:nvPr/>
        </p:nvSpPr>
        <p:spPr>
          <a:xfrm>
            <a:off x="157695" y="1049569"/>
            <a:ext cx="25860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A9749A4E-CAD7-ED8C-7DFA-78D576CB8B63}"/>
              </a:ext>
            </a:extLst>
          </p:cNvPr>
          <p:cNvCxnSpPr/>
          <p:nvPr/>
        </p:nvCxnSpPr>
        <p:spPr>
          <a:xfrm>
            <a:off x="414642" y="626173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E4811675-594A-ADB8-3F3B-8AE1728B4DBC}"/>
              </a:ext>
            </a:extLst>
          </p:cNvPr>
          <p:cNvCxnSpPr/>
          <p:nvPr/>
        </p:nvCxnSpPr>
        <p:spPr>
          <a:xfrm>
            <a:off x="414642" y="916275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47DCC73-56E2-5B19-0847-490D01BF12D7}"/>
              </a:ext>
            </a:extLst>
          </p:cNvPr>
          <p:cNvCxnSpPr/>
          <p:nvPr/>
        </p:nvCxnSpPr>
        <p:spPr>
          <a:xfrm>
            <a:off x="414642" y="1163738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A79DDD69-949F-AD38-6A5C-436D03AECAD9}"/>
              </a:ext>
            </a:extLst>
          </p:cNvPr>
          <p:cNvCxnSpPr/>
          <p:nvPr/>
        </p:nvCxnSpPr>
        <p:spPr>
          <a:xfrm>
            <a:off x="414642" y="1357129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BB9579C1-F095-1E64-245E-76C9796E8963}"/>
              </a:ext>
            </a:extLst>
          </p:cNvPr>
          <p:cNvSpPr txBox="1"/>
          <p:nvPr/>
        </p:nvSpPr>
        <p:spPr>
          <a:xfrm>
            <a:off x="157695" y="1476778"/>
            <a:ext cx="25860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E9AC919-4678-8B11-32AB-E94124F18B79}"/>
              </a:ext>
            </a:extLst>
          </p:cNvPr>
          <p:cNvCxnSpPr/>
          <p:nvPr/>
        </p:nvCxnSpPr>
        <p:spPr>
          <a:xfrm>
            <a:off x="414642" y="1597931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F04E9974-0CFD-10FF-E385-7CBCF24F3C75}"/>
              </a:ext>
            </a:extLst>
          </p:cNvPr>
          <p:cNvSpPr txBox="1"/>
          <p:nvPr/>
        </p:nvSpPr>
        <p:spPr>
          <a:xfrm>
            <a:off x="155649" y="1695853"/>
            <a:ext cx="25860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D16E7B9-5D51-5C5E-3934-7AA5DDA8C0AC}"/>
              </a:ext>
            </a:extLst>
          </p:cNvPr>
          <p:cNvCxnSpPr/>
          <p:nvPr/>
        </p:nvCxnSpPr>
        <p:spPr>
          <a:xfrm>
            <a:off x="412596" y="1817007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2486BF02-7B10-3830-D87D-22E6DE76FC9B}"/>
              </a:ext>
            </a:extLst>
          </p:cNvPr>
          <p:cNvSpPr txBox="1"/>
          <p:nvPr/>
        </p:nvSpPr>
        <p:spPr>
          <a:xfrm>
            <a:off x="153602" y="1899454"/>
            <a:ext cx="25860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34699E5B-95CA-F67C-280A-B305A144528C}"/>
              </a:ext>
            </a:extLst>
          </p:cNvPr>
          <p:cNvCxnSpPr/>
          <p:nvPr/>
        </p:nvCxnSpPr>
        <p:spPr>
          <a:xfrm>
            <a:off x="410550" y="2015402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69D0C317-278F-1FD1-68C3-08A2E083091E}"/>
              </a:ext>
            </a:extLst>
          </p:cNvPr>
          <p:cNvSpPr txBox="1"/>
          <p:nvPr/>
        </p:nvSpPr>
        <p:spPr>
          <a:xfrm>
            <a:off x="90032" y="12732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4EEEF440-F6BC-77EC-1E3D-15E68B1138F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12" t="-778" r="488" b="140"/>
          <a:stretch/>
        </p:blipFill>
        <p:spPr>
          <a:xfrm rot="16200000">
            <a:off x="3138184" y="-392940"/>
            <a:ext cx="2072914" cy="32747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Rectangle 44">
            <a:extLst>
              <a:ext uri="{FF2B5EF4-FFF2-40B4-BE49-F238E27FC236}">
                <a16:creationId xmlns:a16="http://schemas.microsoft.com/office/drawing/2014/main" id="{1AA66DD2-225F-1473-2E1B-FEA076E365A7}"/>
              </a:ext>
            </a:extLst>
          </p:cNvPr>
          <p:cNvSpPr/>
          <p:nvPr/>
        </p:nvSpPr>
        <p:spPr>
          <a:xfrm>
            <a:off x="4340754" y="488164"/>
            <a:ext cx="441967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9ADD64FC-BAB6-B708-F262-4376D8FE628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26" t="95" r="463" b="236"/>
          <a:stretch/>
        </p:blipFill>
        <p:spPr>
          <a:xfrm rot="16200000">
            <a:off x="6528140" y="-377895"/>
            <a:ext cx="2025283" cy="32067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7" name="Rectangle 46">
            <a:extLst>
              <a:ext uri="{FF2B5EF4-FFF2-40B4-BE49-F238E27FC236}">
                <a16:creationId xmlns:a16="http://schemas.microsoft.com/office/drawing/2014/main" id="{1F43D52E-7FB1-C862-3C40-C1EE0A8575D3}"/>
              </a:ext>
            </a:extLst>
          </p:cNvPr>
          <p:cNvSpPr/>
          <p:nvPr/>
        </p:nvSpPr>
        <p:spPr>
          <a:xfrm>
            <a:off x="7538039" y="499198"/>
            <a:ext cx="441967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8758D3BF-DBA7-0786-844A-1841E0552F6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" t="369" r="-1243" b="278"/>
          <a:stretch/>
        </p:blipFill>
        <p:spPr>
          <a:xfrm rot="16200000">
            <a:off x="9068287" y="402780"/>
            <a:ext cx="2312663" cy="18030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9" name="Rectangle 48">
            <a:extLst>
              <a:ext uri="{FF2B5EF4-FFF2-40B4-BE49-F238E27FC236}">
                <a16:creationId xmlns:a16="http://schemas.microsoft.com/office/drawing/2014/main" id="{77098554-098F-E32D-1DD4-8F03182941B4}"/>
              </a:ext>
            </a:extLst>
          </p:cNvPr>
          <p:cNvSpPr/>
          <p:nvPr/>
        </p:nvSpPr>
        <p:spPr>
          <a:xfrm>
            <a:off x="9782651" y="881606"/>
            <a:ext cx="441967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6454C5C0-4DA0-8A34-AFA1-14FBD39F14D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6" t="-248" r="32" b="-110"/>
          <a:stretch/>
        </p:blipFill>
        <p:spPr>
          <a:xfrm rot="16200000">
            <a:off x="1116187" y="1598932"/>
            <a:ext cx="1798195" cy="35208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Rectangle 50">
            <a:extLst>
              <a:ext uri="{FF2B5EF4-FFF2-40B4-BE49-F238E27FC236}">
                <a16:creationId xmlns:a16="http://schemas.microsoft.com/office/drawing/2014/main" id="{2A155228-9BA8-021A-FAFF-C80688D5ECCF}"/>
              </a:ext>
            </a:extLst>
          </p:cNvPr>
          <p:cNvSpPr/>
          <p:nvPr/>
        </p:nvSpPr>
        <p:spPr>
          <a:xfrm>
            <a:off x="754302" y="2918114"/>
            <a:ext cx="441967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1F34BF2E-F268-05A0-F12A-DEA399FF0B30}"/>
              </a:ext>
            </a:extLst>
          </p:cNvPr>
          <p:cNvSpPr/>
          <p:nvPr/>
        </p:nvSpPr>
        <p:spPr>
          <a:xfrm>
            <a:off x="1261762" y="2918114"/>
            <a:ext cx="441967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B1576D1B-852F-6DE4-352F-B92C0C011F0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" t="-1325" r="383" b="729"/>
          <a:stretch/>
        </p:blipFill>
        <p:spPr>
          <a:xfrm rot="16200000">
            <a:off x="3618007" y="2683493"/>
            <a:ext cx="2272089" cy="18256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5" name="Rectangle 54">
            <a:extLst>
              <a:ext uri="{FF2B5EF4-FFF2-40B4-BE49-F238E27FC236}">
                <a16:creationId xmlns:a16="http://schemas.microsoft.com/office/drawing/2014/main" id="{FB58FD7B-044B-BA3A-F8C9-0EC8E4F0005E}"/>
              </a:ext>
            </a:extLst>
          </p:cNvPr>
          <p:cNvSpPr/>
          <p:nvPr/>
        </p:nvSpPr>
        <p:spPr>
          <a:xfrm>
            <a:off x="4252228" y="3418499"/>
            <a:ext cx="441967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48C0B18C-F84C-50B0-FF04-641AE156B0C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2" t="484" r="-378" b="-1568"/>
          <a:stretch/>
        </p:blipFill>
        <p:spPr>
          <a:xfrm rot="16200000">
            <a:off x="5666018" y="2612962"/>
            <a:ext cx="2242896" cy="19375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7" name="Rectangle 56">
            <a:extLst>
              <a:ext uri="{FF2B5EF4-FFF2-40B4-BE49-F238E27FC236}">
                <a16:creationId xmlns:a16="http://schemas.microsoft.com/office/drawing/2014/main" id="{5B89060D-1E80-86E1-2C74-E928A7F36A23}"/>
              </a:ext>
            </a:extLst>
          </p:cNvPr>
          <p:cNvSpPr/>
          <p:nvPr/>
        </p:nvSpPr>
        <p:spPr>
          <a:xfrm>
            <a:off x="6393124" y="3512817"/>
            <a:ext cx="441967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914DE69-5414-6DF2-E06D-5CD0332AEE80}"/>
              </a:ext>
            </a:extLst>
          </p:cNvPr>
          <p:cNvSpPr txBox="1"/>
          <p:nvPr/>
        </p:nvSpPr>
        <p:spPr>
          <a:xfrm>
            <a:off x="4300514" y="264113"/>
            <a:ext cx="45467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8757BC9-DA04-DAB3-23DD-6E5B95D8845D}"/>
              </a:ext>
            </a:extLst>
          </p:cNvPr>
          <p:cNvSpPr txBox="1"/>
          <p:nvPr/>
        </p:nvSpPr>
        <p:spPr>
          <a:xfrm>
            <a:off x="7532870" y="277737"/>
            <a:ext cx="446721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904E73F-46B0-A561-5EE5-7E49B146417A}"/>
              </a:ext>
            </a:extLst>
          </p:cNvPr>
          <p:cNvSpPr txBox="1"/>
          <p:nvPr/>
        </p:nvSpPr>
        <p:spPr>
          <a:xfrm>
            <a:off x="9782651" y="666221"/>
            <a:ext cx="338088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18AC72D-CD00-48E3-9097-692016882328}"/>
              </a:ext>
            </a:extLst>
          </p:cNvPr>
          <p:cNvSpPr txBox="1"/>
          <p:nvPr/>
        </p:nvSpPr>
        <p:spPr>
          <a:xfrm>
            <a:off x="344412" y="2690217"/>
            <a:ext cx="756723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epsilon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CFBEEAE-5106-31DC-9002-E462C0126BD7}"/>
              </a:ext>
            </a:extLst>
          </p:cNvPr>
          <p:cNvSpPr txBox="1"/>
          <p:nvPr/>
        </p:nvSpPr>
        <p:spPr>
          <a:xfrm>
            <a:off x="1231949" y="2689535"/>
            <a:ext cx="634842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zeta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721681E-C0E4-5378-1588-AFD8B187FB03}"/>
              </a:ext>
            </a:extLst>
          </p:cNvPr>
          <p:cNvSpPr txBox="1"/>
          <p:nvPr/>
        </p:nvSpPr>
        <p:spPr>
          <a:xfrm>
            <a:off x="4131981" y="3598815"/>
            <a:ext cx="65074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PAN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3B74715-9612-B95C-61E0-12C956F436DB}"/>
              </a:ext>
            </a:extLst>
          </p:cNvPr>
          <p:cNvSpPr txBox="1"/>
          <p:nvPr/>
        </p:nvSpPr>
        <p:spPr>
          <a:xfrm>
            <a:off x="6335825" y="3240259"/>
            <a:ext cx="556563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36452399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78ADE4A-438C-230C-83B5-503F7654774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826" t="56349" r="28595" b="20582"/>
          <a:stretch/>
        </p:blipFill>
        <p:spPr>
          <a:xfrm rot="16200000">
            <a:off x="908106" y="185956"/>
            <a:ext cx="262177" cy="9072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20499FC-DD56-7E03-CAC2-19719021744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58" t="55725" r="58763" b="21206"/>
          <a:stretch/>
        </p:blipFill>
        <p:spPr>
          <a:xfrm rot="16200000">
            <a:off x="2827210" y="177760"/>
            <a:ext cx="262177" cy="9094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2CC580C-4796-86E0-645D-C8239C71B157}"/>
              </a:ext>
            </a:extLst>
          </p:cNvPr>
          <p:cNvSpPr txBox="1"/>
          <p:nvPr/>
        </p:nvSpPr>
        <p:spPr>
          <a:xfrm>
            <a:off x="714978" y="335008"/>
            <a:ext cx="12595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C6F9D67-968B-FDD9-FA5C-65F7B145DC9B}"/>
              </a:ext>
            </a:extLst>
          </p:cNvPr>
          <p:cNvSpPr txBox="1"/>
          <p:nvPr/>
        </p:nvSpPr>
        <p:spPr>
          <a:xfrm>
            <a:off x="575303" y="335008"/>
            <a:ext cx="12595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3EBED1D-15E8-936A-5DE6-BB43E028C678}"/>
              </a:ext>
            </a:extLst>
          </p:cNvPr>
          <p:cNvSpPr txBox="1"/>
          <p:nvPr/>
        </p:nvSpPr>
        <p:spPr>
          <a:xfrm>
            <a:off x="854655" y="339351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5478A42-0825-F529-74F8-667F8D28174B}"/>
              </a:ext>
            </a:extLst>
          </p:cNvPr>
          <p:cNvSpPr txBox="1"/>
          <p:nvPr/>
        </p:nvSpPr>
        <p:spPr>
          <a:xfrm>
            <a:off x="1191154" y="331697"/>
            <a:ext cx="12595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A6A478C-5C31-3E2C-D78C-F6E257458615}"/>
              </a:ext>
            </a:extLst>
          </p:cNvPr>
          <p:cNvSpPr txBox="1"/>
          <p:nvPr/>
        </p:nvSpPr>
        <p:spPr>
          <a:xfrm>
            <a:off x="1051479" y="331697"/>
            <a:ext cx="12595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E518A97-8510-B04F-A7A8-34F817FDBB7C}"/>
              </a:ext>
            </a:extLst>
          </p:cNvPr>
          <p:cNvSpPr txBox="1"/>
          <p:nvPr/>
        </p:nvSpPr>
        <p:spPr>
          <a:xfrm>
            <a:off x="1330831" y="336040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54C57B-F1D7-77E5-9C6B-1D833082F2C3}"/>
              </a:ext>
            </a:extLst>
          </p:cNvPr>
          <p:cNvSpPr txBox="1"/>
          <p:nvPr/>
        </p:nvSpPr>
        <p:spPr>
          <a:xfrm>
            <a:off x="541940" y="158601"/>
            <a:ext cx="281591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3F0C026-B6D9-C8D6-5053-802DCBADD36A}"/>
              </a:ext>
            </a:extLst>
          </p:cNvPr>
          <p:cNvSpPr txBox="1"/>
          <p:nvPr/>
        </p:nvSpPr>
        <p:spPr>
          <a:xfrm>
            <a:off x="1027937" y="158601"/>
            <a:ext cx="274351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 I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81FCF2F-843A-18D8-8DC9-C5B9EA003539}"/>
              </a:ext>
            </a:extLst>
          </p:cNvPr>
          <p:cNvSpPr txBox="1"/>
          <p:nvPr/>
        </p:nvSpPr>
        <p:spPr>
          <a:xfrm>
            <a:off x="1474526" y="340832"/>
            <a:ext cx="54854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171000D-3A0B-38E2-9F7C-F4E1F2F0C10A}"/>
              </a:ext>
            </a:extLst>
          </p:cNvPr>
          <p:cNvCxnSpPr>
            <a:cxnSpLocks/>
          </p:cNvCxnSpPr>
          <p:nvPr/>
        </p:nvCxnSpPr>
        <p:spPr>
          <a:xfrm>
            <a:off x="613699" y="358170"/>
            <a:ext cx="35188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3DB6821-3786-FF0B-9D1B-90D13F53954E}"/>
              </a:ext>
            </a:extLst>
          </p:cNvPr>
          <p:cNvCxnSpPr>
            <a:cxnSpLocks/>
          </p:cNvCxnSpPr>
          <p:nvPr/>
        </p:nvCxnSpPr>
        <p:spPr>
          <a:xfrm>
            <a:off x="1084241" y="358170"/>
            <a:ext cx="35188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58951EC0-D6CE-218C-DEBA-B4C6D48CF63E}"/>
              </a:ext>
            </a:extLst>
          </p:cNvPr>
          <p:cNvSpPr txBox="1"/>
          <p:nvPr/>
        </p:nvSpPr>
        <p:spPr>
          <a:xfrm>
            <a:off x="180133" y="327967"/>
            <a:ext cx="220060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C1B761F-E02D-A757-BBB2-0B026E62FAD9}"/>
              </a:ext>
            </a:extLst>
          </p:cNvPr>
          <p:cNvSpPr txBox="1"/>
          <p:nvPr/>
        </p:nvSpPr>
        <p:spPr>
          <a:xfrm>
            <a:off x="485715" y="1678520"/>
            <a:ext cx="13067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 14-3-3 epsilon OE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46E4DD0-54E0-DFF1-1C4D-ABAB5070A2B5}"/>
              </a:ext>
            </a:extLst>
          </p:cNvPr>
          <p:cNvSpPr txBox="1"/>
          <p:nvPr/>
        </p:nvSpPr>
        <p:spPr>
          <a:xfrm>
            <a:off x="1474395" y="563936"/>
            <a:ext cx="31054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B8BD3CC-A2B3-AF48-E94B-EC8880AD4AD8}"/>
              </a:ext>
            </a:extLst>
          </p:cNvPr>
          <p:cNvSpPr txBox="1"/>
          <p:nvPr/>
        </p:nvSpPr>
        <p:spPr>
          <a:xfrm>
            <a:off x="1478599" y="910522"/>
            <a:ext cx="305117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00B21A-C206-338F-89DE-0730859C1C1D}"/>
              </a:ext>
            </a:extLst>
          </p:cNvPr>
          <p:cNvSpPr txBox="1"/>
          <p:nvPr/>
        </p:nvSpPr>
        <p:spPr>
          <a:xfrm>
            <a:off x="1478599" y="1137882"/>
            <a:ext cx="550151" cy="3052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epsilo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2C67577-1B58-393E-D2EA-F5D2DB7906BC}"/>
              </a:ext>
            </a:extLst>
          </p:cNvPr>
          <p:cNvSpPr txBox="1"/>
          <p:nvPr/>
        </p:nvSpPr>
        <p:spPr>
          <a:xfrm>
            <a:off x="1474395" y="1446972"/>
            <a:ext cx="194724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0369C45-4BAC-13AF-9170-CEFECB7B1509}"/>
              </a:ext>
            </a:extLst>
          </p:cNvPr>
          <p:cNvSpPr txBox="1"/>
          <p:nvPr/>
        </p:nvSpPr>
        <p:spPr>
          <a:xfrm>
            <a:off x="2625759" y="335008"/>
            <a:ext cx="12595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AA5B154-B96C-D2E5-8DC3-AC489CB035FC}"/>
              </a:ext>
            </a:extLst>
          </p:cNvPr>
          <p:cNvSpPr txBox="1"/>
          <p:nvPr/>
        </p:nvSpPr>
        <p:spPr>
          <a:xfrm>
            <a:off x="2486084" y="335008"/>
            <a:ext cx="12595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D26E7EB-60BB-5216-9977-32392269DC96}"/>
              </a:ext>
            </a:extLst>
          </p:cNvPr>
          <p:cNvSpPr txBox="1"/>
          <p:nvPr/>
        </p:nvSpPr>
        <p:spPr>
          <a:xfrm>
            <a:off x="2765435" y="339351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4B235F6-DC87-4838-FAB6-6EBA07E95F48}"/>
              </a:ext>
            </a:extLst>
          </p:cNvPr>
          <p:cNvSpPr txBox="1"/>
          <p:nvPr/>
        </p:nvSpPr>
        <p:spPr>
          <a:xfrm>
            <a:off x="3101935" y="331697"/>
            <a:ext cx="12595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A5A84BD-ECC4-0FF4-A4C8-AF5F1BABE1D0}"/>
              </a:ext>
            </a:extLst>
          </p:cNvPr>
          <p:cNvSpPr txBox="1"/>
          <p:nvPr/>
        </p:nvSpPr>
        <p:spPr>
          <a:xfrm>
            <a:off x="2962259" y="331697"/>
            <a:ext cx="12595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23DADA3-71FA-4B08-D91E-FFF58DCE08BF}"/>
              </a:ext>
            </a:extLst>
          </p:cNvPr>
          <p:cNvSpPr txBox="1"/>
          <p:nvPr/>
        </p:nvSpPr>
        <p:spPr>
          <a:xfrm>
            <a:off x="3241611" y="336040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B639137-7639-652D-6BB3-3EBD63F56E16}"/>
              </a:ext>
            </a:extLst>
          </p:cNvPr>
          <p:cNvSpPr txBox="1"/>
          <p:nvPr/>
        </p:nvSpPr>
        <p:spPr>
          <a:xfrm>
            <a:off x="2452721" y="158601"/>
            <a:ext cx="281591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61C73D5-8B3A-8727-8017-4DB0B3D1012F}"/>
              </a:ext>
            </a:extLst>
          </p:cNvPr>
          <p:cNvSpPr txBox="1"/>
          <p:nvPr/>
        </p:nvSpPr>
        <p:spPr>
          <a:xfrm>
            <a:off x="2938718" y="158601"/>
            <a:ext cx="274351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 IP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2B9CEE6-A277-A0A3-1578-CCD85F5280CF}"/>
              </a:ext>
            </a:extLst>
          </p:cNvPr>
          <p:cNvSpPr txBox="1"/>
          <p:nvPr/>
        </p:nvSpPr>
        <p:spPr>
          <a:xfrm>
            <a:off x="3385306" y="340832"/>
            <a:ext cx="54854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26D124CC-1F47-12A7-EF74-6F7F306F4773}"/>
              </a:ext>
            </a:extLst>
          </p:cNvPr>
          <p:cNvCxnSpPr>
            <a:cxnSpLocks/>
          </p:cNvCxnSpPr>
          <p:nvPr/>
        </p:nvCxnSpPr>
        <p:spPr>
          <a:xfrm>
            <a:off x="2524480" y="358170"/>
            <a:ext cx="35188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EFBF66B-9AA7-F363-E749-7F9F33BF0108}"/>
              </a:ext>
            </a:extLst>
          </p:cNvPr>
          <p:cNvCxnSpPr>
            <a:cxnSpLocks/>
          </p:cNvCxnSpPr>
          <p:nvPr/>
        </p:nvCxnSpPr>
        <p:spPr>
          <a:xfrm>
            <a:off x="2995022" y="358170"/>
            <a:ext cx="35188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8D52738A-F5D9-5F83-CC6A-C41B156F194A}"/>
              </a:ext>
            </a:extLst>
          </p:cNvPr>
          <p:cNvSpPr txBox="1"/>
          <p:nvPr/>
        </p:nvSpPr>
        <p:spPr>
          <a:xfrm>
            <a:off x="2413972" y="1678520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 14-3-3 zeta OE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76D00EA-2BF7-7D31-8CA3-B8BE18BEC5CB}"/>
              </a:ext>
            </a:extLst>
          </p:cNvPr>
          <p:cNvSpPr txBox="1"/>
          <p:nvPr/>
        </p:nvSpPr>
        <p:spPr>
          <a:xfrm>
            <a:off x="3385176" y="563936"/>
            <a:ext cx="31054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4BDFCDF-D485-A954-1B0B-3209B54A90E8}"/>
              </a:ext>
            </a:extLst>
          </p:cNvPr>
          <p:cNvSpPr txBox="1"/>
          <p:nvPr/>
        </p:nvSpPr>
        <p:spPr>
          <a:xfrm>
            <a:off x="3389380" y="910522"/>
            <a:ext cx="305117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DC2992C-ECF0-7101-AD65-1447252C453C}"/>
              </a:ext>
            </a:extLst>
          </p:cNvPr>
          <p:cNvSpPr txBox="1"/>
          <p:nvPr/>
        </p:nvSpPr>
        <p:spPr>
          <a:xfrm>
            <a:off x="3389379" y="1137882"/>
            <a:ext cx="550151" cy="3052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zet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6986668-B0A4-E9D1-BB18-C7E1A891B30B}"/>
              </a:ext>
            </a:extLst>
          </p:cNvPr>
          <p:cNvSpPr txBox="1"/>
          <p:nvPr/>
        </p:nvSpPr>
        <p:spPr>
          <a:xfrm>
            <a:off x="3385176" y="1446972"/>
            <a:ext cx="194724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B2DC71C6-883B-CB22-095A-95553B90151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90" t="15332" r="61955" b="61668"/>
          <a:stretch/>
        </p:blipFill>
        <p:spPr>
          <a:xfrm rot="16200000">
            <a:off x="2828080" y="783152"/>
            <a:ext cx="261818" cy="910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0C21338C-6E5E-24BE-FD8B-C4E178DB6BF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93" t="15877" r="14858" b="62287"/>
          <a:stretch/>
        </p:blipFill>
        <p:spPr>
          <a:xfrm rot="16200000">
            <a:off x="910079" y="484572"/>
            <a:ext cx="261818" cy="910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4ECC2388-904F-A913-9045-BFA3F3215A2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49" t="15347" r="48702" b="62817"/>
          <a:stretch/>
        </p:blipFill>
        <p:spPr>
          <a:xfrm rot="16200000">
            <a:off x="2828080" y="480200"/>
            <a:ext cx="261818" cy="910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0175750C-159B-A4D4-522B-B083FF69AF3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566" t="15524" r="28420" b="62640"/>
          <a:stretch/>
        </p:blipFill>
        <p:spPr>
          <a:xfrm rot="16200000">
            <a:off x="910079" y="784804"/>
            <a:ext cx="261818" cy="910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7494F116-67B3-16B7-FD28-5B122C6E3C6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56" t="29076" r="51941" b="23349"/>
          <a:stretch/>
        </p:blipFill>
        <p:spPr>
          <a:xfrm rot="16200000">
            <a:off x="2828080" y="1086104"/>
            <a:ext cx="261818" cy="910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4AC6EA7E-007E-CC16-2846-36A114F1EC3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742" t="29472" r="19097" b="29871"/>
          <a:stretch/>
        </p:blipFill>
        <p:spPr>
          <a:xfrm rot="16200000">
            <a:off x="910079" y="1085037"/>
            <a:ext cx="261818" cy="910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C8C89A76-962A-AAF5-813F-8C8343BD5551}"/>
              </a:ext>
            </a:extLst>
          </p:cNvPr>
          <p:cNvSpPr txBox="1"/>
          <p:nvPr/>
        </p:nvSpPr>
        <p:spPr>
          <a:xfrm>
            <a:off x="148900" y="104710"/>
            <a:ext cx="227948" cy="228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240B5E3-A3FE-6807-FCBF-422C44BBF862}"/>
              </a:ext>
            </a:extLst>
          </p:cNvPr>
          <p:cNvSpPr txBox="1"/>
          <p:nvPr/>
        </p:nvSpPr>
        <p:spPr>
          <a:xfrm>
            <a:off x="1988439" y="104710"/>
            <a:ext cx="269626" cy="228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2F746F0-87A5-A0BE-83F9-140609319D8B}"/>
              </a:ext>
            </a:extLst>
          </p:cNvPr>
          <p:cNvSpPr txBox="1"/>
          <p:nvPr/>
        </p:nvSpPr>
        <p:spPr>
          <a:xfrm>
            <a:off x="175302" y="492942"/>
            <a:ext cx="37702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001482A-D68C-8D3B-C595-7B084B0EE787}"/>
              </a:ext>
            </a:extLst>
          </p:cNvPr>
          <p:cNvSpPr txBox="1"/>
          <p:nvPr/>
        </p:nvSpPr>
        <p:spPr>
          <a:xfrm>
            <a:off x="223477" y="903295"/>
            <a:ext cx="235091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E7A9B0F-0346-8B4F-7AB5-6BA2DA0A433A}"/>
              </a:ext>
            </a:extLst>
          </p:cNvPr>
          <p:cNvSpPr txBox="1"/>
          <p:nvPr/>
        </p:nvSpPr>
        <p:spPr>
          <a:xfrm>
            <a:off x="223477" y="1207001"/>
            <a:ext cx="31290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854A0172-51C2-593D-4DA3-1BAB7AF105D5}"/>
              </a:ext>
            </a:extLst>
          </p:cNvPr>
          <p:cNvCxnSpPr/>
          <p:nvPr/>
        </p:nvCxnSpPr>
        <p:spPr>
          <a:xfrm>
            <a:off x="476757" y="59015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3740578F-3717-6925-BE4C-C354AFDE097A}"/>
              </a:ext>
            </a:extLst>
          </p:cNvPr>
          <p:cNvCxnSpPr>
            <a:cxnSpLocks/>
          </p:cNvCxnSpPr>
          <p:nvPr/>
        </p:nvCxnSpPr>
        <p:spPr>
          <a:xfrm>
            <a:off x="476757" y="99447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07AA5C4C-B46B-81DD-8143-04A440D536EA}"/>
              </a:ext>
            </a:extLst>
          </p:cNvPr>
          <p:cNvCxnSpPr/>
          <p:nvPr/>
        </p:nvCxnSpPr>
        <p:spPr>
          <a:xfrm>
            <a:off x="476757" y="130749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A25E148B-A922-9AE2-52D0-769551FFD0DF}"/>
              </a:ext>
            </a:extLst>
          </p:cNvPr>
          <p:cNvSpPr txBox="1"/>
          <p:nvPr/>
        </p:nvSpPr>
        <p:spPr>
          <a:xfrm>
            <a:off x="223477" y="1523562"/>
            <a:ext cx="31290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5D1E5C57-510F-6C8D-C1F5-6BBECCFD7DFA}"/>
              </a:ext>
            </a:extLst>
          </p:cNvPr>
          <p:cNvCxnSpPr/>
          <p:nvPr/>
        </p:nvCxnSpPr>
        <p:spPr>
          <a:xfrm>
            <a:off x="476757" y="1624052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B3CA123A-671C-2359-8D4E-35C309C9200A}"/>
              </a:ext>
            </a:extLst>
          </p:cNvPr>
          <p:cNvSpPr txBox="1"/>
          <p:nvPr/>
        </p:nvSpPr>
        <p:spPr>
          <a:xfrm>
            <a:off x="2108846" y="346415"/>
            <a:ext cx="220060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89563C0-71EA-D265-2BA1-343E1E6FA569}"/>
              </a:ext>
            </a:extLst>
          </p:cNvPr>
          <p:cNvSpPr txBox="1"/>
          <p:nvPr/>
        </p:nvSpPr>
        <p:spPr>
          <a:xfrm>
            <a:off x="2104015" y="511390"/>
            <a:ext cx="37702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113E33D-E823-FB23-A71E-AB314A061B60}"/>
              </a:ext>
            </a:extLst>
          </p:cNvPr>
          <p:cNvSpPr txBox="1"/>
          <p:nvPr/>
        </p:nvSpPr>
        <p:spPr>
          <a:xfrm>
            <a:off x="2152190" y="921743"/>
            <a:ext cx="235091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73202BD-78EE-621C-CA18-DB3C92E4248B}"/>
              </a:ext>
            </a:extLst>
          </p:cNvPr>
          <p:cNvSpPr txBox="1"/>
          <p:nvPr/>
        </p:nvSpPr>
        <p:spPr>
          <a:xfrm>
            <a:off x="2152190" y="1225449"/>
            <a:ext cx="31290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8AF9C873-39C2-4F71-E81C-8ED7551DB8E7}"/>
              </a:ext>
            </a:extLst>
          </p:cNvPr>
          <p:cNvCxnSpPr/>
          <p:nvPr/>
        </p:nvCxnSpPr>
        <p:spPr>
          <a:xfrm>
            <a:off x="2405470" y="60860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DD31C02D-387A-CD18-909D-949004841F55}"/>
              </a:ext>
            </a:extLst>
          </p:cNvPr>
          <p:cNvCxnSpPr/>
          <p:nvPr/>
        </p:nvCxnSpPr>
        <p:spPr>
          <a:xfrm>
            <a:off x="2405470" y="1012918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6D52DCC1-F459-ED42-C47E-1BAAC2EB82AB}"/>
              </a:ext>
            </a:extLst>
          </p:cNvPr>
          <p:cNvCxnSpPr/>
          <p:nvPr/>
        </p:nvCxnSpPr>
        <p:spPr>
          <a:xfrm>
            <a:off x="2405470" y="1325939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061A6492-7DFF-3270-5F2E-370D2486DAAD}"/>
              </a:ext>
            </a:extLst>
          </p:cNvPr>
          <p:cNvSpPr txBox="1"/>
          <p:nvPr/>
        </p:nvSpPr>
        <p:spPr>
          <a:xfrm>
            <a:off x="2152190" y="1542010"/>
            <a:ext cx="31290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48F72A73-FC74-76C9-2401-B28B141097DC}"/>
              </a:ext>
            </a:extLst>
          </p:cNvPr>
          <p:cNvCxnSpPr/>
          <p:nvPr/>
        </p:nvCxnSpPr>
        <p:spPr>
          <a:xfrm>
            <a:off x="2405470" y="164250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2" name="Picture 61">
            <a:extLst>
              <a:ext uri="{FF2B5EF4-FFF2-40B4-BE49-F238E27FC236}">
                <a16:creationId xmlns:a16="http://schemas.microsoft.com/office/drawing/2014/main" id="{69250386-2478-9F4A-140C-064F1CC7EC8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0" t="2220" r="2057" b="397"/>
          <a:stretch/>
        </p:blipFill>
        <p:spPr>
          <a:xfrm rot="16200000">
            <a:off x="4193160" y="4477"/>
            <a:ext cx="2547635" cy="28772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3" name="Rectangle 62">
            <a:extLst>
              <a:ext uri="{FF2B5EF4-FFF2-40B4-BE49-F238E27FC236}">
                <a16:creationId xmlns:a16="http://schemas.microsoft.com/office/drawing/2014/main" id="{3B734407-C7FF-E528-0101-EC9772992642}"/>
              </a:ext>
            </a:extLst>
          </p:cNvPr>
          <p:cNvSpPr/>
          <p:nvPr/>
        </p:nvSpPr>
        <p:spPr>
          <a:xfrm>
            <a:off x="5613758" y="873810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178DCCDF-5BD2-2CD8-9196-35A597EBB21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" t="10" r="-386" b="1027"/>
          <a:stretch/>
        </p:blipFill>
        <p:spPr>
          <a:xfrm rot="16200000">
            <a:off x="7641908" y="-465312"/>
            <a:ext cx="1815417" cy="31012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5" name="Rectangle 64">
            <a:extLst>
              <a:ext uri="{FF2B5EF4-FFF2-40B4-BE49-F238E27FC236}">
                <a16:creationId xmlns:a16="http://schemas.microsoft.com/office/drawing/2014/main" id="{2EE4C978-EF55-F567-8AC4-CF883EAF9EA8}"/>
              </a:ext>
            </a:extLst>
          </p:cNvPr>
          <p:cNvSpPr/>
          <p:nvPr/>
        </p:nvSpPr>
        <p:spPr>
          <a:xfrm>
            <a:off x="7487851" y="492942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6" name="Picture 65">
            <a:extLst>
              <a:ext uri="{FF2B5EF4-FFF2-40B4-BE49-F238E27FC236}">
                <a16:creationId xmlns:a16="http://schemas.microsoft.com/office/drawing/2014/main" id="{E5370589-53EF-CFB2-A156-403BD8CA872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" t="1399" r="-563" b="1381"/>
          <a:stretch/>
        </p:blipFill>
        <p:spPr>
          <a:xfrm rot="16200000">
            <a:off x="72341" y="2265224"/>
            <a:ext cx="2979612" cy="276970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7" name="Rectangle 66">
            <a:extLst>
              <a:ext uri="{FF2B5EF4-FFF2-40B4-BE49-F238E27FC236}">
                <a16:creationId xmlns:a16="http://schemas.microsoft.com/office/drawing/2014/main" id="{C3B79577-3E94-BE52-A5A6-5791892DF5E2}"/>
              </a:ext>
            </a:extLst>
          </p:cNvPr>
          <p:cNvSpPr/>
          <p:nvPr/>
        </p:nvSpPr>
        <p:spPr>
          <a:xfrm>
            <a:off x="542340" y="3028381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8" name="Picture 67">
            <a:extLst>
              <a:ext uri="{FF2B5EF4-FFF2-40B4-BE49-F238E27FC236}">
                <a16:creationId xmlns:a16="http://schemas.microsoft.com/office/drawing/2014/main" id="{91955B37-CC30-7176-E653-F88CCC239E2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" t="275" r="-16" b="616"/>
          <a:stretch/>
        </p:blipFill>
        <p:spPr>
          <a:xfrm rot="16200000">
            <a:off x="2300298" y="2891851"/>
            <a:ext cx="2903440" cy="151645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9" name="Rectangle 68">
            <a:extLst>
              <a:ext uri="{FF2B5EF4-FFF2-40B4-BE49-F238E27FC236}">
                <a16:creationId xmlns:a16="http://schemas.microsoft.com/office/drawing/2014/main" id="{8B9EE7AB-6B5E-E4EC-DED1-B425AD1AC1E6}"/>
              </a:ext>
            </a:extLst>
          </p:cNvPr>
          <p:cNvSpPr/>
          <p:nvPr/>
        </p:nvSpPr>
        <p:spPr>
          <a:xfrm>
            <a:off x="3384823" y="2779489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75140910-5B64-0934-5BC9-33B998E3462E}"/>
              </a:ext>
            </a:extLst>
          </p:cNvPr>
          <p:cNvSpPr/>
          <p:nvPr/>
        </p:nvSpPr>
        <p:spPr>
          <a:xfrm>
            <a:off x="5572701" y="1676030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5C186D48-D4FA-FF7F-8E12-CBB3DD7310A2}"/>
              </a:ext>
            </a:extLst>
          </p:cNvPr>
          <p:cNvSpPr/>
          <p:nvPr/>
        </p:nvSpPr>
        <p:spPr>
          <a:xfrm>
            <a:off x="7487851" y="1135376"/>
            <a:ext cx="711792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73" name="Picture 72">
            <a:extLst>
              <a:ext uri="{FF2B5EF4-FFF2-40B4-BE49-F238E27FC236}">
                <a16:creationId xmlns:a16="http://schemas.microsoft.com/office/drawing/2014/main" id="{3A25B2C7-9223-529F-A904-DF58C0EF707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63" t="31" r="-311" b="1024"/>
          <a:stretch/>
        </p:blipFill>
        <p:spPr>
          <a:xfrm rot="16200000">
            <a:off x="4896639" y="2426906"/>
            <a:ext cx="2238627" cy="29437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4" name="Rectangle 73">
            <a:extLst>
              <a:ext uri="{FF2B5EF4-FFF2-40B4-BE49-F238E27FC236}">
                <a16:creationId xmlns:a16="http://schemas.microsoft.com/office/drawing/2014/main" id="{6393CE93-EBC3-54BA-F3C3-800E7645DAF9}"/>
              </a:ext>
            </a:extLst>
          </p:cNvPr>
          <p:cNvSpPr/>
          <p:nvPr/>
        </p:nvSpPr>
        <p:spPr>
          <a:xfrm>
            <a:off x="4996138" y="4177216"/>
            <a:ext cx="711792" cy="1837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75" name="Picture 74">
            <a:extLst>
              <a:ext uri="{FF2B5EF4-FFF2-40B4-BE49-F238E27FC236}">
                <a16:creationId xmlns:a16="http://schemas.microsoft.com/office/drawing/2014/main" id="{E7FC17E4-03BB-27CB-F459-D5FDCB2AC57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" t="-573" r="677" b="2388"/>
          <a:stretch/>
        </p:blipFill>
        <p:spPr>
          <a:xfrm rot="16200000">
            <a:off x="6496720" y="3114514"/>
            <a:ext cx="3528042" cy="14122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6" name="Rectangle 75">
            <a:extLst>
              <a:ext uri="{FF2B5EF4-FFF2-40B4-BE49-F238E27FC236}">
                <a16:creationId xmlns:a16="http://schemas.microsoft.com/office/drawing/2014/main" id="{6F9E56A8-3D80-3A51-A31B-CC8E3C7362A4}"/>
              </a:ext>
            </a:extLst>
          </p:cNvPr>
          <p:cNvSpPr/>
          <p:nvPr/>
        </p:nvSpPr>
        <p:spPr>
          <a:xfrm>
            <a:off x="7952470" y="3898804"/>
            <a:ext cx="711792" cy="1837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CD6EE99-C480-B371-46D2-F7F0B8D08668}"/>
              </a:ext>
            </a:extLst>
          </p:cNvPr>
          <p:cNvSpPr txBox="1"/>
          <p:nvPr/>
        </p:nvSpPr>
        <p:spPr>
          <a:xfrm>
            <a:off x="6414359" y="845373"/>
            <a:ext cx="31054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B6C73C7-6642-576C-E493-8662E688CF91}"/>
              </a:ext>
            </a:extLst>
          </p:cNvPr>
          <p:cNvSpPr txBox="1"/>
          <p:nvPr/>
        </p:nvSpPr>
        <p:spPr>
          <a:xfrm>
            <a:off x="6373302" y="1649183"/>
            <a:ext cx="31054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E8235F6-1FB8-631C-FC93-46EAA51EABE8}"/>
              </a:ext>
            </a:extLst>
          </p:cNvPr>
          <p:cNvSpPr txBox="1"/>
          <p:nvPr/>
        </p:nvSpPr>
        <p:spPr>
          <a:xfrm>
            <a:off x="6905616" y="443322"/>
            <a:ext cx="305117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A42444C-E51D-9DA1-9FD7-BC25981EF461}"/>
              </a:ext>
            </a:extLst>
          </p:cNvPr>
          <p:cNvSpPr txBox="1"/>
          <p:nvPr/>
        </p:nvSpPr>
        <p:spPr>
          <a:xfrm>
            <a:off x="6925004" y="1081518"/>
            <a:ext cx="305117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5E455B6-4950-3E92-47F3-5136C38BF9DB}"/>
              </a:ext>
            </a:extLst>
          </p:cNvPr>
          <p:cNvSpPr txBox="1"/>
          <p:nvPr/>
        </p:nvSpPr>
        <p:spPr>
          <a:xfrm>
            <a:off x="979056" y="3205939"/>
            <a:ext cx="550151" cy="3052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epsilon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6B1D5EE-2D8E-A69E-F96F-B218A3A2D507}"/>
              </a:ext>
            </a:extLst>
          </p:cNvPr>
          <p:cNvSpPr txBox="1"/>
          <p:nvPr/>
        </p:nvSpPr>
        <p:spPr>
          <a:xfrm>
            <a:off x="4885073" y="4422554"/>
            <a:ext cx="550151" cy="3052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zeta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F547E264-08A2-1365-3F84-457951B4A656}"/>
              </a:ext>
            </a:extLst>
          </p:cNvPr>
          <p:cNvSpPr txBox="1"/>
          <p:nvPr/>
        </p:nvSpPr>
        <p:spPr>
          <a:xfrm>
            <a:off x="4143666" y="2714340"/>
            <a:ext cx="194724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6F06B023-4EE9-CD4E-2D44-E7A726D7BD17}"/>
              </a:ext>
            </a:extLst>
          </p:cNvPr>
          <p:cNvSpPr txBox="1"/>
          <p:nvPr/>
        </p:nvSpPr>
        <p:spPr>
          <a:xfrm>
            <a:off x="8664262" y="3898804"/>
            <a:ext cx="194724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</p:spTree>
    <p:extLst>
      <p:ext uri="{BB962C8B-B14F-4D97-AF65-F5344CB8AC3E}">
        <p14:creationId xmlns:p14="http://schemas.microsoft.com/office/powerpoint/2010/main" val="5146847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BB21309-55F1-C66F-729D-0ABDDF2B0A4A}"/>
              </a:ext>
            </a:extLst>
          </p:cNvPr>
          <p:cNvSpPr txBox="1"/>
          <p:nvPr/>
        </p:nvSpPr>
        <p:spPr>
          <a:xfrm>
            <a:off x="225880" y="27256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47DDBDD-8937-F180-3B2A-237865FD13A4}"/>
              </a:ext>
            </a:extLst>
          </p:cNvPr>
          <p:cNvSpPr txBox="1"/>
          <p:nvPr/>
        </p:nvSpPr>
        <p:spPr>
          <a:xfrm>
            <a:off x="1238735" y="405953"/>
            <a:ext cx="797421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siRN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995F3D9-E86C-074A-C5D4-D688925DC126}"/>
              </a:ext>
            </a:extLst>
          </p:cNvPr>
          <p:cNvSpPr txBox="1"/>
          <p:nvPr/>
        </p:nvSpPr>
        <p:spPr>
          <a:xfrm>
            <a:off x="769978" y="407632"/>
            <a:ext cx="459969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04356C5-86C3-5D34-7B0D-7829220B29A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322" t="12270" r="19045" b="62206"/>
          <a:stretch/>
        </p:blipFill>
        <p:spPr>
          <a:xfrm rot="16200000">
            <a:off x="1240739" y="619929"/>
            <a:ext cx="277105" cy="12192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66DDE94-2E8D-A5EA-35DB-50364A077E5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899" t="12359" r="24468" b="62117"/>
          <a:stretch/>
        </p:blipFill>
        <p:spPr>
          <a:xfrm rot="16200000">
            <a:off x="1240739" y="909800"/>
            <a:ext cx="277105" cy="12192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18061A4-1BF9-CDF6-96DD-4B06EAAFAE5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11" t="74370" r="30049" b="16305"/>
          <a:stretch/>
        </p:blipFill>
        <p:spPr>
          <a:xfrm>
            <a:off x="769660" y="1670751"/>
            <a:ext cx="1219264" cy="2771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C4931B2-A3BE-4E41-EB5E-FB0C43BF6E5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881" t="19809" r="21511" b="56467"/>
          <a:stretch/>
        </p:blipFill>
        <p:spPr>
          <a:xfrm rot="16200000">
            <a:off x="1240739" y="330057"/>
            <a:ext cx="277105" cy="12192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2CED1DC-B283-4DF0-34F2-9F4A879454C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81" t="19544" r="33611" b="56732"/>
          <a:stretch/>
        </p:blipFill>
        <p:spPr>
          <a:xfrm rot="16200000">
            <a:off x="1240739" y="1489544"/>
            <a:ext cx="277105" cy="12192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E1B3164-763B-5A5C-6A22-4F24487E062F}"/>
              </a:ext>
            </a:extLst>
          </p:cNvPr>
          <p:cNvSpPr txBox="1"/>
          <p:nvPr/>
        </p:nvSpPr>
        <p:spPr>
          <a:xfrm>
            <a:off x="719864" y="600981"/>
            <a:ext cx="205608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60922D-6496-CB48-A68C-F5DE4E0D2DF5}"/>
              </a:ext>
            </a:extLst>
          </p:cNvPr>
          <p:cNvSpPr txBox="1"/>
          <p:nvPr/>
        </p:nvSpPr>
        <p:spPr>
          <a:xfrm>
            <a:off x="836157" y="600981"/>
            <a:ext cx="2586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FBA4DC1-C798-6583-5E81-7FC9A4F92611}"/>
              </a:ext>
            </a:extLst>
          </p:cNvPr>
          <p:cNvSpPr txBox="1"/>
          <p:nvPr/>
        </p:nvSpPr>
        <p:spPr>
          <a:xfrm>
            <a:off x="996787" y="600981"/>
            <a:ext cx="2586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CD9DAE5-D40C-2A42-BB19-A27E439565F6}"/>
              </a:ext>
            </a:extLst>
          </p:cNvPr>
          <p:cNvSpPr txBox="1"/>
          <p:nvPr/>
        </p:nvSpPr>
        <p:spPr>
          <a:xfrm>
            <a:off x="1157417" y="600981"/>
            <a:ext cx="2586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4A7C88D-0CEA-2A24-9D6B-03C67259F0B8}"/>
              </a:ext>
            </a:extLst>
          </p:cNvPr>
          <p:cNvSpPr txBox="1"/>
          <p:nvPr/>
        </p:nvSpPr>
        <p:spPr>
          <a:xfrm>
            <a:off x="1948515" y="600980"/>
            <a:ext cx="867505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min) 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44B60C5E-801C-13B5-5A39-9618B679C7DC}"/>
              </a:ext>
            </a:extLst>
          </p:cNvPr>
          <p:cNvCxnSpPr>
            <a:cxnSpLocks/>
          </p:cNvCxnSpPr>
          <p:nvPr/>
        </p:nvCxnSpPr>
        <p:spPr>
          <a:xfrm>
            <a:off x="797986" y="611572"/>
            <a:ext cx="50497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609292E4-BC60-0D99-109C-C22AF07B771F}"/>
              </a:ext>
            </a:extLst>
          </p:cNvPr>
          <p:cNvCxnSpPr>
            <a:cxnSpLocks/>
          </p:cNvCxnSpPr>
          <p:nvPr/>
        </p:nvCxnSpPr>
        <p:spPr>
          <a:xfrm>
            <a:off x="1392336" y="611572"/>
            <a:ext cx="50497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664A6D31-74EC-4798-C3EE-0B5AC11A6B14}"/>
              </a:ext>
            </a:extLst>
          </p:cNvPr>
          <p:cNvSpPr txBox="1"/>
          <p:nvPr/>
        </p:nvSpPr>
        <p:spPr>
          <a:xfrm>
            <a:off x="1988924" y="911359"/>
            <a:ext cx="45467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FB51032-CB65-2E1E-FD54-CD66B56B059B}"/>
              </a:ext>
            </a:extLst>
          </p:cNvPr>
          <p:cNvSpPr txBox="1"/>
          <p:nvPr/>
        </p:nvSpPr>
        <p:spPr>
          <a:xfrm>
            <a:off x="1991602" y="1170445"/>
            <a:ext cx="446722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D024485-727B-0F6B-AEF6-FD334A9633CE}"/>
              </a:ext>
            </a:extLst>
          </p:cNvPr>
          <p:cNvSpPr txBox="1"/>
          <p:nvPr/>
        </p:nvSpPr>
        <p:spPr>
          <a:xfrm>
            <a:off x="457262" y="948460"/>
            <a:ext cx="2586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6392B4D-94F0-C261-7C24-1EDE3F12863C}"/>
              </a:ext>
            </a:extLst>
          </p:cNvPr>
          <p:cNvSpPr txBox="1"/>
          <p:nvPr/>
        </p:nvSpPr>
        <p:spPr>
          <a:xfrm>
            <a:off x="457262" y="1093728"/>
            <a:ext cx="2586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4E752A4-DA1E-CD65-CC38-D68DAFE63B2A}"/>
              </a:ext>
            </a:extLst>
          </p:cNvPr>
          <p:cNvSpPr txBox="1"/>
          <p:nvPr/>
        </p:nvSpPr>
        <p:spPr>
          <a:xfrm>
            <a:off x="457262" y="1419716"/>
            <a:ext cx="2586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7FD8710-F23F-EC79-B8B5-FDD9774EAAD3}"/>
              </a:ext>
            </a:extLst>
          </p:cNvPr>
          <p:cNvSpPr txBox="1"/>
          <p:nvPr/>
        </p:nvSpPr>
        <p:spPr>
          <a:xfrm>
            <a:off x="1991601" y="1728598"/>
            <a:ext cx="634842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zet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7D235EA-E01F-3277-C72D-013A197D6BF5}"/>
              </a:ext>
            </a:extLst>
          </p:cNvPr>
          <p:cNvSpPr txBox="1"/>
          <p:nvPr/>
        </p:nvSpPr>
        <p:spPr>
          <a:xfrm>
            <a:off x="1986966" y="1446822"/>
            <a:ext cx="756724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epsilo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0FA348E-25ED-EF0A-948C-F218D20F61FF}"/>
              </a:ext>
            </a:extLst>
          </p:cNvPr>
          <p:cNvSpPr txBox="1"/>
          <p:nvPr/>
        </p:nvSpPr>
        <p:spPr>
          <a:xfrm>
            <a:off x="1983496" y="2046107"/>
            <a:ext cx="692497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89B852A-5A21-C598-225C-C562C5EF49F1}"/>
              </a:ext>
            </a:extLst>
          </p:cNvPr>
          <p:cNvSpPr txBox="1"/>
          <p:nvPr/>
        </p:nvSpPr>
        <p:spPr>
          <a:xfrm>
            <a:off x="1318046" y="600981"/>
            <a:ext cx="205608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77DC89C-4A2B-E545-19C3-0BC7C70DA3D4}"/>
              </a:ext>
            </a:extLst>
          </p:cNvPr>
          <p:cNvSpPr txBox="1"/>
          <p:nvPr/>
        </p:nvSpPr>
        <p:spPr>
          <a:xfrm>
            <a:off x="1434340" y="600981"/>
            <a:ext cx="2586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9515FDF-8983-131D-BED7-A64D55820020}"/>
              </a:ext>
            </a:extLst>
          </p:cNvPr>
          <p:cNvSpPr txBox="1"/>
          <p:nvPr/>
        </p:nvSpPr>
        <p:spPr>
          <a:xfrm>
            <a:off x="1594970" y="600981"/>
            <a:ext cx="2586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D749BC9-0D00-1545-6DB9-381959E0F185}"/>
              </a:ext>
            </a:extLst>
          </p:cNvPr>
          <p:cNvSpPr txBox="1"/>
          <p:nvPr/>
        </p:nvSpPr>
        <p:spPr>
          <a:xfrm>
            <a:off x="1755601" y="600981"/>
            <a:ext cx="2586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F9FB644-F69A-FDBD-D619-EF741A0753BE}"/>
              </a:ext>
            </a:extLst>
          </p:cNvPr>
          <p:cNvSpPr txBox="1"/>
          <p:nvPr/>
        </p:nvSpPr>
        <p:spPr>
          <a:xfrm>
            <a:off x="700456" y="2206870"/>
            <a:ext cx="146776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 - nuclear fractio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A2CAA51-DBD2-F4E3-FA17-1209B7DA3D91}"/>
              </a:ext>
            </a:extLst>
          </p:cNvPr>
          <p:cNvSpPr txBox="1"/>
          <p:nvPr/>
        </p:nvSpPr>
        <p:spPr>
          <a:xfrm>
            <a:off x="457262" y="1699684"/>
            <a:ext cx="2586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19A9AA1-F5A6-C173-50C5-05AD0335DAFA}"/>
              </a:ext>
            </a:extLst>
          </p:cNvPr>
          <p:cNvSpPr txBox="1"/>
          <p:nvPr/>
        </p:nvSpPr>
        <p:spPr>
          <a:xfrm>
            <a:off x="457262" y="1960623"/>
            <a:ext cx="2586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6C99257-6559-9D5F-D145-439F51D70B73}"/>
              </a:ext>
            </a:extLst>
          </p:cNvPr>
          <p:cNvSpPr txBox="1"/>
          <p:nvPr/>
        </p:nvSpPr>
        <p:spPr>
          <a:xfrm>
            <a:off x="452332" y="608162"/>
            <a:ext cx="32219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53E85CF5-1DA5-E860-FF62-F8BA0E3E173F}"/>
              </a:ext>
            </a:extLst>
          </p:cNvPr>
          <p:cNvCxnSpPr/>
          <p:nvPr/>
        </p:nvCxnSpPr>
        <p:spPr>
          <a:xfrm>
            <a:off x="678998" y="1054010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2802C4F2-486D-C750-4C06-E73812041D8D}"/>
              </a:ext>
            </a:extLst>
          </p:cNvPr>
          <p:cNvCxnSpPr/>
          <p:nvPr/>
        </p:nvCxnSpPr>
        <p:spPr>
          <a:xfrm>
            <a:off x="678998" y="1193736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2B4E43A6-F207-5302-554C-8C0892E0ECB0}"/>
              </a:ext>
            </a:extLst>
          </p:cNvPr>
          <p:cNvCxnSpPr/>
          <p:nvPr/>
        </p:nvCxnSpPr>
        <p:spPr>
          <a:xfrm>
            <a:off x="678998" y="1520421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30C423C0-D2D3-AD84-9CBF-463B225ED1A3}"/>
              </a:ext>
            </a:extLst>
          </p:cNvPr>
          <p:cNvCxnSpPr/>
          <p:nvPr/>
        </p:nvCxnSpPr>
        <p:spPr>
          <a:xfrm>
            <a:off x="678998" y="1805777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6DDBC83F-7012-1D02-003D-8FFC90D96568}"/>
              </a:ext>
            </a:extLst>
          </p:cNvPr>
          <p:cNvCxnSpPr/>
          <p:nvPr/>
        </p:nvCxnSpPr>
        <p:spPr>
          <a:xfrm>
            <a:off x="676568" y="2067518"/>
            <a:ext cx="519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9" name="Picture 38">
            <a:extLst>
              <a:ext uri="{FF2B5EF4-FFF2-40B4-BE49-F238E27FC236}">
                <a16:creationId xmlns:a16="http://schemas.microsoft.com/office/drawing/2014/main" id="{2EDC9A07-B912-8463-8456-5A769AF7EF5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6" t="16" r="592" b="831"/>
          <a:stretch/>
        </p:blipFill>
        <p:spPr>
          <a:xfrm rot="16200000">
            <a:off x="3476118" y="-214620"/>
            <a:ext cx="3098665" cy="382860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6FF6C189-B7CB-857D-ED5B-89EC80171A92}"/>
              </a:ext>
            </a:extLst>
          </p:cNvPr>
          <p:cNvSpPr/>
          <p:nvPr/>
        </p:nvSpPr>
        <p:spPr>
          <a:xfrm>
            <a:off x="3853301" y="846659"/>
            <a:ext cx="947395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E50A9C78-3297-E205-416A-CD796B3C8D5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2" t="545" r="-999" b="1351"/>
          <a:stretch/>
        </p:blipFill>
        <p:spPr>
          <a:xfrm rot="16200000">
            <a:off x="7248792" y="-37930"/>
            <a:ext cx="3144325" cy="35208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Rectangle 41">
            <a:extLst>
              <a:ext uri="{FF2B5EF4-FFF2-40B4-BE49-F238E27FC236}">
                <a16:creationId xmlns:a16="http://schemas.microsoft.com/office/drawing/2014/main" id="{33E39D63-5F68-57E3-0003-F3F8F355982E}"/>
              </a:ext>
            </a:extLst>
          </p:cNvPr>
          <p:cNvSpPr/>
          <p:nvPr/>
        </p:nvSpPr>
        <p:spPr>
          <a:xfrm>
            <a:off x="7424458" y="770001"/>
            <a:ext cx="947395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3B62162F-1AD9-7158-3E51-6E884E9A742C}"/>
              </a:ext>
            </a:extLst>
          </p:cNvPr>
          <p:cNvSpPr/>
          <p:nvPr/>
        </p:nvSpPr>
        <p:spPr>
          <a:xfrm>
            <a:off x="7408979" y="970505"/>
            <a:ext cx="947395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34A8A854-837F-060D-7637-DDC4C9AA6E3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4" t="197" r="1106" b="759"/>
          <a:stretch/>
        </p:blipFill>
        <p:spPr>
          <a:xfrm>
            <a:off x="93125" y="3429000"/>
            <a:ext cx="3520889" cy="29432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9" name="Rectangle 48">
            <a:extLst>
              <a:ext uri="{FF2B5EF4-FFF2-40B4-BE49-F238E27FC236}">
                <a16:creationId xmlns:a16="http://schemas.microsoft.com/office/drawing/2014/main" id="{B0AA2246-5CC2-9C44-BDEC-1743D6BC1585}"/>
              </a:ext>
            </a:extLst>
          </p:cNvPr>
          <p:cNvSpPr/>
          <p:nvPr/>
        </p:nvSpPr>
        <p:spPr>
          <a:xfrm>
            <a:off x="3820385" y="1222328"/>
            <a:ext cx="947395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7F1C43CF-B49A-E3D5-05F0-0787F469BF94}"/>
              </a:ext>
            </a:extLst>
          </p:cNvPr>
          <p:cNvSpPr/>
          <p:nvPr/>
        </p:nvSpPr>
        <p:spPr>
          <a:xfrm>
            <a:off x="1361627" y="5700208"/>
            <a:ext cx="947395" cy="1670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1B4DC6B-5683-E1B6-6882-FB376E799302}"/>
              </a:ext>
            </a:extLst>
          </p:cNvPr>
          <p:cNvSpPr txBox="1"/>
          <p:nvPr/>
        </p:nvSpPr>
        <p:spPr>
          <a:xfrm>
            <a:off x="4248854" y="596723"/>
            <a:ext cx="45467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22A4DE3-9CB8-4EA6-B392-43A34DEAE92C}"/>
              </a:ext>
            </a:extLst>
          </p:cNvPr>
          <p:cNvSpPr txBox="1"/>
          <p:nvPr/>
        </p:nvSpPr>
        <p:spPr>
          <a:xfrm>
            <a:off x="7674794" y="562299"/>
            <a:ext cx="446722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0EE8791-4496-82A2-99F1-B1BD2DA2BF91}"/>
              </a:ext>
            </a:extLst>
          </p:cNvPr>
          <p:cNvSpPr txBox="1"/>
          <p:nvPr/>
        </p:nvSpPr>
        <p:spPr>
          <a:xfrm>
            <a:off x="7305253" y="1141484"/>
            <a:ext cx="756724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epsil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97D9837-33B8-0A66-8DCA-D52F75DD7D1F}"/>
              </a:ext>
            </a:extLst>
          </p:cNvPr>
          <p:cNvSpPr txBox="1"/>
          <p:nvPr/>
        </p:nvSpPr>
        <p:spPr>
          <a:xfrm>
            <a:off x="1305648" y="5883437"/>
            <a:ext cx="634842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zet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5783FA6-5CD4-5AA1-912D-3F546F84CBF8}"/>
              </a:ext>
            </a:extLst>
          </p:cNvPr>
          <p:cNvSpPr txBox="1"/>
          <p:nvPr/>
        </p:nvSpPr>
        <p:spPr>
          <a:xfrm>
            <a:off x="3450056" y="1389338"/>
            <a:ext cx="692497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3K36Me3</a:t>
            </a:r>
          </a:p>
        </p:txBody>
      </p:sp>
    </p:spTree>
    <p:extLst>
      <p:ext uri="{BB962C8B-B14F-4D97-AF65-F5344CB8AC3E}">
        <p14:creationId xmlns:p14="http://schemas.microsoft.com/office/powerpoint/2010/main" val="2109427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324</Words>
  <Application>Microsoft Office PowerPoint</Application>
  <PresentationFormat>Widescreen</PresentationFormat>
  <Paragraphs>22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2</cp:revision>
  <dcterms:created xsi:type="dcterms:W3CDTF">2024-05-10T10:54:52Z</dcterms:created>
  <dcterms:modified xsi:type="dcterms:W3CDTF">2024-05-10T12:37:56Z</dcterms:modified>
</cp:coreProperties>
</file>